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154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F904567-1496-26FD-59B2-275298C438AB}" v="24" dt="2023-08-05T06:18:47.697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556" autoAdjust="0"/>
  </p:normalViewPr>
  <p:slideViewPr>
    <p:cSldViewPr snapToGrid="0">
      <p:cViewPr varScale="1">
        <p:scale>
          <a:sx n="99" d="100"/>
          <a:sy n="99" d="100"/>
        </p:scale>
        <p:origin x="60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築家　恵美" userId="f8a515c7-036c-4132-9fc2-097c41d54ccb" providerId="ADAL" clId="{1B8125CE-B87B-4FD0-983C-AD18CCE8E72D}"/>
    <pc:docChg chg="undo custSel modSld">
      <pc:chgData name="築家　恵美" userId="f8a515c7-036c-4132-9fc2-097c41d54ccb" providerId="ADAL" clId="{1B8125CE-B87B-4FD0-983C-AD18CCE8E72D}" dt="2022-12-09T10:42:48.557" v="293" actId="12788"/>
      <pc:docMkLst>
        <pc:docMk/>
      </pc:docMkLst>
      <pc:sldChg chg="addSp delSp modSp mod">
        <pc:chgData name="築家　恵美" userId="f8a515c7-036c-4132-9fc2-097c41d54ccb" providerId="ADAL" clId="{1B8125CE-B87B-4FD0-983C-AD18CCE8E72D}" dt="2022-12-09T10:42:48.557" v="293" actId="12788"/>
        <pc:sldMkLst>
          <pc:docMk/>
          <pc:sldMk cId="2851950515" sldId="1547"/>
        </pc:sldMkLst>
        <pc:spChg chg="mod">
          <ac:chgData name="築家　恵美" userId="f8a515c7-036c-4132-9fc2-097c41d54ccb" providerId="ADAL" clId="{1B8125CE-B87B-4FD0-983C-AD18CCE8E72D}" dt="2022-12-09T02:59:41.787" v="263" actId="20577"/>
          <ac:spMkLst>
            <pc:docMk/>
            <pc:sldMk cId="2851950515" sldId="1547"/>
            <ac:spMk id="2" creationId="{B80B36E8-F9F9-431F-99A2-B7594DBF4711}"/>
          </ac:spMkLst>
        </pc:spChg>
        <pc:spChg chg="mod">
          <ac:chgData name="築家　恵美" userId="f8a515c7-036c-4132-9fc2-097c41d54ccb" providerId="ADAL" clId="{1B8125CE-B87B-4FD0-983C-AD18CCE8E72D}" dt="2022-12-09T10:42:48.557" v="293" actId="12788"/>
          <ac:spMkLst>
            <pc:docMk/>
            <pc:sldMk cId="2851950515" sldId="1547"/>
            <ac:spMk id="12" creationId="{443B432C-E7EF-43E1-A922-96AF55CE5CCA}"/>
          </ac:spMkLst>
        </pc:spChg>
        <pc:spChg chg="mod">
          <ac:chgData name="築家　恵美" userId="f8a515c7-036c-4132-9fc2-097c41d54ccb" providerId="ADAL" clId="{1B8125CE-B87B-4FD0-983C-AD18CCE8E72D}" dt="2022-12-09T10:42:31.137" v="287" actId="20577"/>
          <ac:spMkLst>
            <pc:docMk/>
            <pc:sldMk cId="2851950515" sldId="1547"/>
            <ac:spMk id="13" creationId="{21696853-FAF2-492B-A959-96D21B782645}"/>
          </ac:spMkLst>
        </pc:spChg>
        <pc:spChg chg="mod">
          <ac:chgData name="築家　恵美" userId="f8a515c7-036c-4132-9fc2-097c41d54ccb" providerId="ADAL" clId="{1B8125CE-B87B-4FD0-983C-AD18CCE8E72D}" dt="2022-12-09T10:42:48.557" v="293" actId="12788"/>
          <ac:spMkLst>
            <pc:docMk/>
            <pc:sldMk cId="2851950515" sldId="1547"/>
            <ac:spMk id="14" creationId="{2072F15C-001C-4DF3-BC33-361F2B8AD709}"/>
          </ac:spMkLst>
        </pc:spChg>
        <pc:spChg chg="mod">
          <ac:chgData name="築家　恵美" userId="f8a515c7-036c-4132-9fc2-097c41d54ccb" providerId="ADAL" clId="{1B8125CE-B87B-4FD0-983C-AD18CCE8E72D}" dt="2022-12-09T02:58:48.683" v="245" actId="20577"/>
          <ac:spMkLst>
            <pc:docMk/>
            <pc:sldMk cId="2851950515" sldId="1547"/>
            <ac:spMk id="15" creationId="{7141E4D3-468E-4BA0-87E8-69CED0C3E111}"/>
          </ac:spMkLst>
        </pc:spChg>
        <pc:spChg chg="mod">
          <ac:chgData name="築家　恵美" userId="f8a515c7-036c-4132-9fc2-097c41d54ccb" providerId="ADAL" clId="{1B8125CE-B87B-4FD0-983C-AD18CCE8E72D}" dt="2022-12-09T02:58:32.968" v="231" actId="20577"/>
          <ac:spMkLst>
            <pc:docMk/>
            <pc:sldMk cId="2851950515" sldId="1547"/>
            <ac:spMk id="16" creationId="{10F20B14-D218-483F-85B4-A04922286EB9}"/>
          </ac:spMkLst>
        </pc:spChg>
        <pc:spChg chg="mod">
          <ac:chgData name="築家　恵美" userId="f8a515c7-036c-4132-9fc2-097c41d54ccb" providerId="ADAL" clId="{1B8125CE-B87B-4FD0-983C-AD18CCE8E72D}" dt="2022-12-09T02:59:08.423" v="261" actId="20577"/>
          <ac:spMkLst>
            <pc:docMk/>
            <pc:sldMk cId="2851950515" sldId="1547"/>
            <ac:spMk id="17" creationId="{5EFCC239-C17A-4E6B-8B2C-186D783DA2B1}"/>
          </ac:spMkLst>
        </pc:spChg>
        <pc:graphicFrameChg chg="del mod">
          <ac:chgData name="築家　恵美" userId="f8a515c7-036c-4132-9fc2-097c41d54ccb" providerId="ADAL" clId="{1B8125CE-B87B-4FD0-983C-AD18CCE8E72D}" dt="2022-12-09T02:54:17.998" v="210" actId="478"/>
          <ac:graphicFrameMkLst>
            <pc:docMk/>
            <pc:sldMk cId="2851950515" sldId="1547"/>
            <ac:graphicFrameMk id="3" creationId="{F2C967B2-17C4-452C-9CB3-B2E11D88C0BE}"/>
          </ac:graphicFrameMkLst>
        </pc:graphicFrameChg>
        <pc:graphicFrameChg chg="del">
          <ac:chgData name="築家　恵美" userId="f8a515c7-036c-4132-9fc2-097c41d54ccb" providerId="ADAL" clId="{1B8125CE-B87B-4FD0-983C-AD18CCE8E72D}" dt="2022-12-09T02:51:51.742" v="87" actId="478"/>
          <ac:graphicFrameMkLst>
            <pc:docMk/>
            <pc:sldMk cId="2851950515" sldId="1547"/>
            <ac:graphicFrameMk id="4" creationId="{F2C967B2-17C4-452C-9CB3-B2E11D88C0BE}"/>
          </ac:graphicFrameMkLst>
        </pc:graphicFrameChg>
        <pc:graphicFrameChg chg="del">
          <ac:chgData name="築家　恵美" userId="f8a515c7-036c-4132-9fc2-097c41d54ccb" providerId="ADAL" clId="{1B8125CE-B87B-4FD0-983C-AD18CCE8E72D}" dt="2022-12-09T02:47:56.638" v="26" actId="478"/>
          <ac:graphicFrameMkLst>
            <pc:docMk/>
            <pc:sldMk cId="2851950515" sldId="1547"/>
            <ac:graphicFrameMk id="5" creationId="{F2C967B2-17C4-452C-9CB3-B2E11D88C0BE}"/>
          </ac:graphicFrameMkLst>
        </pc:graphicFrameChg>
        <pc:graphicFrameChg chg="add mod ord">
          <ac:chgData name="築家　恵美" userId="f8a515c7-036c-4132-9fc2-097c41d54ccb" providerId="ADAL" clId="{1B8125CE-B87B-4FD0-983C-AD18CCE8E72D}" dt="2022-12-09T02:57:46.670" v="212" actId="167"/>
          <ac:graphicFrameMkLst>
            <pc:docMk/>
            <pc:sldMk cId="2851950515" sldId="1547"/>
            <ac:graphicFrameMk id="18" creationId="{F2C967B2-17C4-452C-9CB3-B2E11D88C0BE}"/>
          </ac:graphicFrameMkLst>
        </pc:graphicFrameChg>
        <pc:graphicFrameChg chg="add mod ord">
          <ac:chgData name="築家　恵美" userId="f8a515c7-036c-4132-9fc2-097c41d54ccb" providerId="ADAL" clId="{1B8125CE-B87B-4FD0-983C-AD18CCE8E72D}" dt="2022-12-09T02:54:08.580" v="207" actId="167"/>
          <ac:graphicFrameMkLst>
            <pc:docMk/>
            <pc:sldMk cId="2851950515" sldId="1547"/>
            <ac:graphicFrameMk id="19" creationId="{F2C967B2-17C4-452C-9CB3-B2E11D88C0BE}"/>
          </ac:graphicFrameMkLst>
        </pc:graphicFrameChg>
        <pc:graphicFrameChg chg="add mod ord">
          <ac:chgData name="築家　恵美" userId="f8a515c7-036c-4132-9fc2-097c41d54ccb" providerId="ADAL" clId="{1B8125CE-B87B-4FD0-983C-AD18CCE8E72D}" dt="2022-12-09T02:58:20.386" v="230" actId="167"/>
          <ac:graphicFrameMkLst>
            <pc:docMk/>
            <pc:sldMk cId="2851950515" sldId="1547"/>
            <ac:graphicFrameMk id="20" creationId="{F2C967B2-17C4-452C-9CB3-B2E11D88C0BE}"/>
          </ac:graphicFrameMkLst>
        </pc:graphicFrameChg>
      </pc:sldChg>
    </pc:docChg>
  </pc:docChgLst>
  <pc:docChgLst>
    <pc:chgData name="佐伯　吉弘" userId="c48215f7-a175-419d-95e9-d9045df60879" providerId="ADAL" clId="{A4C58966-F23D-4AE4-88D3-07B0AA502962}"/>
    <pc:docChg chg="modSld">
      <pc:chgData name="佐伯　吉弘" userId="c48215f7-a175-419d-95e9-d9045df60879" providerId="ADAL" clId="{A4C58966-F23D-4AE4-88D3-07B0AA502962}" dt="2023-08-05T07:03:28.663" v="27" actId="1035"/>
      <pc:docMkLst>
        <pc:docMk/>
      </pc:docMkLst>
      <pc:sldChg chg="modSp mod">
        <pc:chgData name="佐伯　吉弘" userId="c48215f7-a175-419d-95e9-d9045df60879" providerId="ADAL" clId="{A4C58966-F23D-4AE4-88D3-07B0AA502962}" dt="2023-08-05T07:03:28.663" v="27" actId="1035"/>
        <pc:sldMkLst>
          <pc:docMk/>
          <pc:sldMk cId="2851950515" sldId="1547"/>
        </pc:sldMkLst>
        <pc:spChg chg="mod">
          <ac:chgData name="佐伯　吉弘" userId="c48215f7-a175-419d-95e9-d9045df60879" providerId="ADAL" clId="{A4C58966-F23D-4AE4-88D3-07B0AA502962}" dt="2023-08-05T07:03:28.663" v="27" actId="1035"/>
          <ac:spMkLst>
            <pc:docMk/>
            <pc:sldMk cId="2851950515" sldId="1547"/>
            <ac:spMk id="2" creationId="{B80B36E8-F9F9-431F-99A2-B7594DBF4711}"/>
          </ac:spMkLst>
        </pc:spChg>
      </pc:sldChg>
    </pc:docChg>
  </pc:docChgLst>
  <pc:docChgLst>
    <pc:chgData name="築家　恵美" userId="f8a515c7-036c-4132-9fc2-097c41d54ccb" providerId="ADAL" clId="{EAB1B56B-B18F-4E6C-B80A-5DB4D9EE5AF1}"/>
    <pc:docChg chg="modSld">
      <pc:chgData name="築家　恵美" userId="f8a515c7-036c-4132-9fc2-097c41d54ccb" providerId="ADAL" clId="{EAB1B56B-B18F-4E6C-B80A-5DB4D9EE5AF1}" dt="2023-08-01T11:16:41.064" v="3" actId="20577"/>
      <pc:docMkLst>
        <pc:docMk/>
      </pc:docMkLst>
      <pc:sldChg chg="modSp mod">
        <pc:chgData name="築家　恵美" userId="f8a515c7-036c-4132-9fc2-097c41d54ccb" providerId="ADAL" clId="{EAB1B56B-B18F-4E6C-B80A-5DB4D9EE5AF1}" dt="2023-08-01T11:16:41.064" v="3" actId="20577"/>
        <pc:sldMkLst>
          <pc:docMk/>
          <pc:sldMk cId="2851950515" sldId="1547"/>
        </pc:sldMkLst>
        <pc:spChg chg="mod">
          <ac:chgData name="築家　恵美" userId="f8a515c7-036c-4132-9fc2-097c41d54ccb" providerId="ADAL" clId="{EAB1B56B-B18F-4E6C-B80A-5DB4D9EE5AF1}" dt="2023-08-01T11:16:41.064" v="3" actId="20577"/>
          <ac:spMkLst>
            <pc:docMk/>
            <pc:sldMk cId="2851950515" sldId="1547"/>
            <ac:spMk id="2" creationId="{B80B36E8-F9F9-431F-99A2-B7594DBF4711}"/>
          </ac:spMkLst>
        </pc:spChg>
      </pc:sldChg>
    </pc:docChg>
  </pc:docChgLst>
  <pc:docChgLst>
    <pc:chgData name="築家　恵美" userId="f8a515c7-036c-4132-9fc2-097c41d54ccb" providerId="ADAL" clId="{423E0D05-E24E-4CD4-A3C9-F95A3973E7A8}"/>
    <pc:docChg chg="delSld">
      <pc:chgData name="築家　恵美" userId="f8a515c7-036c-4132-9fc2-097c41d54ccb" providerId="ADAL" clId="{423E0D05-E24E-4CD4-A3C9-F95A3973E7A8}" dt="2022-05-27T02:15:19.478" v="1" actId="47"/>
      <pc:docMkLst>
        <pc:docMk/>
      </pc:docMkLst>
      <pc:sldChg chg="del">
        <pc:chgData name="築家　恵美" userId="f8a515c7-036c-4132-9fc2-097c41d54ccb" providerId="ADAL" clId="{423E0D05-E24E-4CD4-A3C9-F95A3973E7A8}" dt="2022-05-27T02:15:17.545" v="0" actId="47"/>
        <pc:sldMkLst>
          <pc:docMk/>
          <pc:sldMk cId="2737564786" sldId="1544"/>
        </pc:sldMkLst>
      </pc:sldChg>
      <pc:sldChg chg="del">
        <pc:chgData name="築家　恵美" userId="f8a515c7-036c-4132-9fc2-097c41d54ccb" providerId="ADAL" clId="{423E0D05-E24E-4CD4-A3C9-F95A3973E7A8}" dt="2022-05-27T02:15:19.478" v="1" actId="47"/>
        <pc:sldMkLst>
          <pc:docMk/>
          <pc:sldMk cId="2656985132" sldId="1545"/>
        </pc:sldMkLst>
      </pc:sldChg>
    </pc:docChg>
  </pc:docChgLst>
  <pc:docChgLst>
    <pc:chgData name="築家　恵美" userId="f8a515c7-036c-4132-9fc2-097c41d54ccb" providerId="ADAL" clId="{6164B3F4-764D-4B0F-8956-69DA9E65C354}"/>
    <pc:docChg chg="undo redo custSel delSld modSld">
      <pc:chgData name="築家　恵美" userId="f8a515c7-036c-4132-9fc2-097c41d54ccb" providerId="ADAL" clId="{6164B3F4-764D-4B0F-8956-69DA9E65C354}" dt="2022-05-06T04:52:51.543" v="595" actId="554"/>
      <pc:docMkLst>
        <pc:docMk/>
      </pc:docMkLst>
      <pc:sldChg chg="del">
        <pc:chgData name="築家　恵美" userId="f8a515c7-036c-4132-9fc2-097c41d54ccb" providerId="ADAL" clId="{6164B3F4-764D-4B0F-8956-69DA9E65C354}" dt="2022-05-06T04:50:20.014" v="592" actId="47"/>
        <pc:sldMkLst>
          <pc:docMk/>
          <pc:sldMk cId="3908323094" sldId="256"/>
        </pc:sldMkLst>
      </pc:sldChg>
      <pc:sldChg chg="del">
        <pc:chgData name="築家　恵美" userId="f8a515c7-036c-4132-9fc2-097c41d54ccb" providerId="ADAL" clId="{6164B3F4-764D-4B0F-8956-69DA9E65C354}" dt="2022-05-06T04:52:31.846" v="593" actId="47"/>
        <pc:sldMkLst>
          <pc:docMk/>
          <pc:sldMk cId="2802955094" sldId="258"/>
        </pc:sldMkLst>
      </pc:sldChg>
      <pc:sldChg chg="del modNotesTx">
        <pc:chgData name="築家　恵美" userId="f8a515c7-036c-4132-9fc2-097c41d54ccb" providerId="ADAL" clId="{6164B3F4-764D-4B0F-8956-69DA9E65C354}" dt="2022-05-06T04:52:31.846" v="593" actId="47"/>
        <pc:sldMkLst>
          <pc:docMk/>
          <pc:sldMk cId="4274357844" sldId="259"/>
        </pc:sldMkLst>
      </pc:sldChg>
      <pc:sldChg chg="modSp del mod">
        <pc:chgData name="築家　恵美" userId="f8a515c7-036c-4132-9fc2-097c41d54ccb" providerId="ADAL" clId="{6164B3F4-764D-4B0F-8956-69DA9E65C354}" dt="2022-05-06T04:52:31.846" v="593" actId="47"/>
        <pc:sldMkLst>
          <pc:docMk/>
          <pc:sldMk cId="3982596869" sldId="263"/>
        </pc:sldMkLst>
        <pc:graphicFrameChg chg="modGraphic">
          <ac:chgData name="築家　恵美" userId="f8a515c7-036c-4132-9fc2-097c41d54ccb" providerId="ADAL" clId="{6164B3F4-764D-4B0F-8956-69DA9E65C354}" dt="2022-05-01T05:59:22.402" v="510" actId="20577"/>
          <ac:graphicFrameMkLst>
            <pc:docMk/>
            <pc:sldMk cId="3982596869" sldId="263"/>
            <ac:graphicFrameMk id="2" creationId="{0823AF79-80AA-4248-85D5-832F9BD2C60A}"/>
          </ac:graphicFrameMkLst>
        </pc:graphicFrameChg>
      </pc:sldChg>
      <pc:sldChg chg="del">
        <pc:chgData name="築家　恵美" userId="f8a515c7-036c-4132-9fc2-097c41d54ccb" providerId="ADAL" clId="{6164B3F4-764D-4B0F-8956-69DA9E65C354}" dt="2022-05-06T04:52:31.846" v="593" actId="47"/>
        <pc:sldMkLst>
          <pc:docMk/>
          <pc:sldMk cId="1582348977" sldId="267"/>
        </pc:sldMkLst>
      </pc:sldChg>
      <pc:sldChg chg="del">
        <pc:chgData name="築家　恵美" userId="f8a515c7-036c-4132-9fc2-097c41d54ccb" providerId="ADAL" clId="{6164B3F4-764D-4B0F-8956-69DA9E65C354}" dt="2022-05-06T04:52:31.846" v="593" actId="47"/>
        <pc:sldMkLst>
          <pc:docMk/>
          <pc:sldMk cId="557135690" sldId="269"/>
        </pc:sldMkLst>
      </pc:sldChg>
      <pc:sldChg chg="modSp del mod">
        <pc:chgData name="築家　恵美" userId="f8a515c7-036c-4132-9fc2-097c41d54ccb" providerId="ADAL" clId="{6164B3F4-764D-4B0F-8956-69DA9E65C354}" dt="2022-05-06T04:52:31.846" v="593" actId="47"/>
        <pc:sldMkLst>
          <pc:docMk/>
          <pc:sldMk cId="4175175410" sldId="1541"/>
        </pc:sldMkLst>
        <pc:spChg chg="mod">
          <ac:chgData name="築家　恵美" userId="f8a515c7-036c-4132-9fc2-097c41d54ccb" providerId="ADAL" clId="{6164B3F4-764D-4B0F-8956-69DA9E65C354}" dt="2022-05-01T02:48:10.104" v="111" actId="1076"/>
          <ac:spMkLst>
            <pc:docMk/>
            <pc:sldMk cId="4175175410" sldId="1541"/>
            <ac:spMk id="9" creationId="{6F38D1FA-F836-4904-83E8-A7032747EA31}"/>
          </ac:spMkLst>
        </pc:spChg>
        <pc:spChg chg="mod">
          <ac:chgData name="築家　恵美" userId="f8a515c7-036c-4132-9fc2-097c41d54ccb" providerId="ADAL" clId="{6164B3F4-764D-4B0F-8956-69DA9E65C354}" dt="2022-05-01T02:49:22.075" v="127" actId="1076"/>
          <ac:spMkLst>
            <pc:docMk/>
            <pc:sldMk cId="4175175410" sldId="1541"/>
            <ac:spMk id="12" creationId="{E5290051-5000-41D4-A2CE-A1F5C7EAB5AD}"/>
          </ac:spMkLst>
        </pc:spChg>
        <pc:spChg chg="mod">
          <ac:chgData name="築家　恵美" userId="f8a515c7-036c-4132-9fc2-097c41d54ccb" providerId="ADAL" clId="{6164B3F4-764D-4B0F-8956-69DA9E65C354}" dt="2022-05-01T02:48:33.564" v="113" actId="1076"/>
          <ac:spMkLst>
            <pc:docMk/>
            <pc:sldMk cId="4175175410" sldId="1541"/>
            <ac:spMk id="19" creationId="{90EE9B4A-169E-4314-8B8A-5440D79C75EF}"/>
          </ac:spMkLst>
        </pc:spChg>
        <pc:spChg chg="mod">
          <ac:chgData name="築家　恵美" userId="f8a515c7-036c-4132-9fc2-097c41d54ccb" providerId="ADAL" clId="{6164B3F4-764D-4B0F-8956-69DA9E65C354}" dt="2022-05-01T02:49:07.846" v="116" actId="1076"/>
          <ac:spMkLst>
            <pc:docMk/>
            <pc:sldMk cId="4175175410" sldId="1541"/>
            <ac:spMk id="20" creationId="{53194B26-BB8C-4E12-9B64-4559B1105B98}"/>
          </ac:spMkLst>
        </pc:spChg>
        <pc:spChg chg="mod">
          <ac:chgData name="築家　恵美" userId="f8a515c7-036c-4132-9fc2-097c41d54ccb" providerId="ADAL" clId="{6164B3F4-764D-4B0F-8956-69DA9E65C354}" dt="2022-05-01T02:49:58.661" v="155" actId="1037"/>
          <ac:spMkLst>
            <pc:docMk/>
            <pc:sldMk cId="4175175410" sldId="1541"/>
            <ac:spMk id="45" creationId="{C4426079-3AD7-4033-8DF3-EA8910013D1B}"/>
          </ac:spMkLst>
        </pc:spChg>
        <pc:spChg chg="mod">
          <ac:chgData name="築家　恵美" userId="f8a515c7-036c-4132-9fc2-097c41d54ccb" providerId="ADAL" clId="{6164B3F4-764D-4B0F-8956-69DA9E65C354}" dt="2022-05-01T02:49:53.642" v="140" actId="1038"/>
          <ac:spMkLst>
            <pc:docMk/>
            <pc:sldMk cId="4175175410" sldId="1541"/>
            <ac:spMk id="46" creationId="{0C99492B-F6B9-468D-A280-636F7D1E3666}"/>
          </ac:spMkLst>
        </pc:spChg>
        <pc:spChg chg="mod">
          <ac:chgData name="築家　恵美" userId="f8a515c7-036c-4132-9fc2-097c41d54ccb" providerId="ADAL" clId="{6164B3F4-764D-4B0F-8956-69DA9E65C354}" dt="2022-05-01T02:50:46.269" v="233" actId="555"/>
          <ac:spMkLst>
            <pc:docMk/>
            <pc:sldMk cId="4175175410" sldId="1541"/>
            <ac:spMk id="47" creationId="{89761972-3068-4B26-87F7-AC7A2E4B5FCD}"/>
          </ac:spMkLst>
        </pc:spChg>
        <pc:spChg chg="mod">
          <ac:chgData name="築家　恵美" userId="f8a515c7-036c-4132-9fc2-097c41d54ccb" providerId="ADAL" clId="{6164B3F4-764D-4B0F-8956-69DA9E65C354}" dt="2022-05-01T02:50:46.269" v="233" actId="555"/>
          <ac:spMkLst>
            <pc:docMk/>
            <pc:sldMk cId="4175175410" sldId="1541"/>
            <ac:spMk id="48" creationId="{D7144D86-DC55-4725-8759-4722169393FF}"/>
          </ac:spMkLst>
        </pc:spChg>
        <pc:spChg chg="mod">
          <ac:chgData name="築家　恵美" userId="f8a515c7-036c-4132-9fc2-097c41d54ccb" providerId="ADAL" clId="{6164B3F4-764D-4B0F-8956-69DA9E65C354}" dt="2022-05-01T02:50:46.269" v="233" actId="555"/>
          <ac:spMkLst>
            <pc:docMk/>
            <pc:sldMk cId="4175175410" sldId="1541"/>
            <ac:spMk id="49" creationId="{DF82923F-E100-4CA6-9595-D8F6A218AD75}"/>
          </ac:spMkLst>
        </pc:spChg>
        <pc:spChg chg="mod">
          <ac:chgData name="築家　恵美" userId="f8a515c7-036c-4132-9fc2-097c41d54ccb" providerId="ADAL" clId="{6164B3F4-764D-4B0F-8956-69DA9E65C354}" dt="2022-05-01T02:50:46.269" v="233" actId="555"/>
          <ac:spMkLst>
            <pc:docMk/>
            <pc:sldMk cId="4175175410" sldId="1541"/>
            <ac:spMk id="50" creationId="{E54C0A07-7CF2-48EA-B691-27B221D5C954}"/>
          </ac:spMkLst>
        </pc:spChg>
        <pc:spChg chg="mod">
          <ac:chgData name="築家　恵美" userId="f8a515c7-036c-4132-9fc2-097c41d54ccb" providerId="ADAL" clId="{6164B3F4-764D-4B0F-8956-69DA9E65C354}" dt="2022-05-01T02:48:43.836" v="114" actId="555"/>
          <ac:spMkLst>
            <pc:docMk/>
            <pc:sldMk cId="4175175410" sldId="1541"/>
            <ac:spMk id="54" creationId="{4F5C1735-1F9D-4E01-B59C-CA0EE9CDA7CD}"/>
          </ac:spMkLst>
        </pc:spChg>
        <pc:spChg chg="mod">
          <ac:chgData name="築家　恵美" userId="f8a515c7-036c-4132-9fc2-097c41d54ccb" providerId="ADAL" clId="{6164B3F4-764D-4B0F-8956-69DA9E65C354}" dt="2022-05-01T02:48:43.836" v="114" actId="555"/>
          <ac:spMkLst>
            <pc:docMk/>
            <pc:sldMk cId="4175175410" sldId="1541"/>
            <ac:spMk id="55" creationId="{563C6633-1111-41C8-9A97-A4FEC6C3F7CA}"/>
          </ac:spMkLst>
        </pc:spChg>
        <pc:spChg chg="mod">
          <ac:chgData name="築家　恵美" userId="f8a515c7-036c-4132-9fc2-097c41d54ccb" providerId="ADAL" clId="{6164B3F4-764D-4B0F-8956-69DA9E65C354}" dt="2022-05-01T02:49:13.238" v="126" actId="1036"/>
          <ac:spMkLst>
            <pc:docMk/>
            <pc:sldMk cId="4175175410" sldId="1541"/>
            <ac:spMk id="56" creationId="{FE9EC1C5-0CDC-4D53-A655-E64F970FB736}"/>
          </ac:spMkLst>
        </pc:spChg>
        <pc:graphicFrameChg chg="mod">
          <ac:chgData name="築家　恵美" userId="f8a515c7-036c-4132-9fc2-097c41d54ccb" providerId="ADAL" clId="{6164B3F4-764D-4B0F-8956-69DA9E65C354}" dt="2022-05-01T02:49:37.966" v="131" actId="1076"/>
          <ac:graphicFrameMkLst>
            <pc:docMk/>
            <pc:sldMk cId="4175175410" sldId="1541"/>
            <ac:graphicFrameMk id="22" creationId="{FAAB50DF-4799-45B7-A149-634EBE36B0A3}"/>
          </ac:graphicFrameMkLst>
        </pc:graphicFrameChg>
        <pc:graphicFrameChg chg="mod">
          <ac:chgData name="築家　恵美" userId="f8a515c7-036c-4132-9fc2-097c41d54ccb" providerId="ADAL" clId="{6164B3F4-764D-4B0F-8956-69DA9E65C354}" dt="2022-05-01T02:47:41.582" v="107" actId="1076"/>
          <ac:graphicFrameMkLst>
            <pc:docMk/>
            <pc:sldMk cId="4175175410" sldId="1541"/>
            <ac:graphicFrameMk id="23" creationId="{CFD31A72-C4EC-41A5-98A5-0FF6EE0B3ED6}"/>
          </ac:graphicFrameMkLst>
        </pc:graphicFrameChg>
        <pc:graphicFrameChg chg="mod">
          <ac:chgData name="築家　恵美" userId="f8a515c7-036c-4132-9fc2-097c41d54ccb" providerId="ADAL" clId="{6164B3F4-764D-4B0F-8956-69DA9E65C354}" dt="2022-05-01T02:47:41.582" v="107" actId="1076"/>
          <ac:graphicFrameMkLst>
            <pc:docMk/>
            <pc:sldMk cId="4175175410" sldId="1541"/>
            <ac:graphicFrameMk id="33" creationId="{CFD31A72-C4EC-41A5-98A5-0FF6EE0B3ED6}"/>
          </ac:graphicFrameMkLst>
        </pc:graphicFrameChg>
        <pc:cxnChg chg="mod">
          <ac:chgData name="築家　恵美" userId="f8a515c7-036c-4132-9fc2-097c41d54ccb" providerId="ADAL" clId="{6164B3F4-764D-4B0F-8956-69DA9E65C354}" dt="2022-05-01T02:49:22.075" v="127" actId="1076"/>
          <ac:cxnSpMkLst>
            <pc:docMk/>
            <pc:sldMk cId="4175175410" sldId="1541"/>
            <ac:cxnSpMk id="8" creationId="{67665785-685A-4226-B5AB-94E635E9CFE5}"/>
          </ac:cxnSpMkLst>
        </pc:cxnChg>
      </pc:sldChg>
      <pc:sldChg chg="modSp mod modNotesTx">
        <pc:chgData name="築家　恵美" userId="f8a515c7-036c-4132-9fc2-097c41d54ccb" providerId="ADAL" clId="{6164B3F4-764D-4B0F-8956-69DA9E65C354}" dt="2022-05-01T04:44:19.551" v="499" actId="1076"/>
        <pc:sldMkLst>
          <pc:docMk/>
          <pc:sldMk cId="2737564786" sldId="1544"/>
        </pc:sldMkLst>
        <pc:spChg chg="mod">
          <ac:chgData name="築家　恵美" userId="f8a515c7-036c-4132-9fc2-097c41d54ccb" providerId="ADAL" clId="{6164B3F4-764D-4B0F-8956-69DA9E65C354}" dt="2022-05-01T04:44:19.551" v="499" actId="1076"/>
          <ac:spMkLst>
            <pc:docMk/>
            <pc:sldMk cId="2737564786" sldId="1544"/>
            <ac:spMk id="2" creationId="{AAB447A1-2784-4E6C-B313-4ABA3B863C89}"/>
          </ac:spMkLst>
        </pc:spChg>
        <pc:spChg chg="mod">
          <ac:chgData name="築家　恵美" userId="f8a515c7-036c-4132-9fc2-097c41d54ccb" providerId="ADAL" clId="{6164B3F4-764D-4B0F-8956-69DA9E65C354}" dt="2022-05-01T04:42:32.629" v="463" actId="1035"/>
          <ac:spMkLst>
            <pc:docMk/>
            <pc:sldMk cId="2737564786" sldId="1544"/>
            <ac:spMk id="3" creationId="{35A9C8DC-D6FE-4AC6-81EF-BD99AD8BAD28}"/>
          </ac:spMkLst>
        </pc:spChg>
        <pc:spChg chg="mod">
          <ac:chgData name="築家　恵美" userId="f8a515c7-036c-4132-9fc2-097c41d54ccb" providerId="ADAL" clId="{6164B3F4-764D-4B0F-8956-69DA9E65C354}" dt="2022-05-01T04:43:21.609" v="483" actId="1037"/>
          <ac:spMkLst>
            <pc:docMk/>
            <pc:sldMk cId="2737564786" sldId="1544"/>
            <ac:spMk id="23" creationId="{4EAADF5A-E106-4677-888D-D7DA03805A5C}"/>
          </ac:spMkLst>
        </pc:spChg>
        <pc:spChg chg="mod">
          <ac:chgData name="築家　恵美" userId="f8a515c7-036c-4132-9fc2-097c41d54ccb" providerId="ADAL" clId="{6164B3F4-764D-4B0F-8956-69DA9E65C354}" dt="2022-05-01T04:42:44.754" v="467" actId="1038"/>
          <ac:spMkLst>
            <pc:docMk/>
            <pc:sldMk cId="2737564786" sldId="1544"/>
            <ac:spMk id="24" creationId="{F2C73E29-822F-4869-99BB-9FE151171E63}"/>
          </ac:spMkLst>
        </pc:spChg>
        <pc:spChg chg="mod">
          <ac:chgData name="築家　恵美" userId="f8a515c7-036c-4132-9fc2-097c41d54ccb" providerId="ADAL" clId="{6164B3F4-764D-4B0F-8956-69DA9E65C354}" dt="2022-05-01T04:43:26.560" v="487" actId="1038"/>
          <ac:spMkLst>
            <pc:docMk/>
            <pc:sldMk cId="2737564786" sldId="1544"/>
            <ac:spMk id="25" creationId="{39629508-9385-4E23-A8A2-E8A3D7329ABE}"/>
          </ac:spMkLst>
        </pc:spChg>
        <pc:spChg chg="mod">
          <ac:chgData name="築家　恵美" userId="f8a515c7-036c-4132-9fc2-097c41d54ccb" providerId="ADAL" clId="{6164B3F4-764D-4B0F-8956-69DA9E65C354}" dt="2022-05-01T04:42:49.984" v="475" actId="1037"/>
          <ac:spMkLst>
            <pc:docMk/>
            <pc:sldMk cId="2737564786" sldId="1544"/>
            <ac:spMk id="26" creationId="{566A6F51-AA85-4E79-96A3-73983FF29AFC}"/>
          </ac:spMkLst>
        </pc:spChg>
        <pc:spChg chg="mod">
          <ac:chgData name="築家　恵美" userId="f8a515c7-036c-4132-9fc2-097c41d54ccb" providerId="ADAL" clId="{6164B3F4-764D-4B0F-8956-69DA9E65C354}" dt="2022-05-01T04:44:19.551" v="499" actId="1076"/>
          <ac:spMkLst>
            <pc:docMk/>
            <pc:sldMk cId="2737564786" sldId="1544"/>
            <ac:spMk id="27" creationId="{5D2909E3-10F9-4298-8E4F-6FC8243417E6}"/>
          </ac:spMkLst>
        </pc:spChg>
        <pc:spChg chg="mod">
          <ac:chgData name="築家　恵美" userId="f8a515c7-036c-4132-9fc2-097c41d54ccb" providerId="ADAL" clId="{6164B3F4-764D-4B0F-8956-69DA9E65C354}" dt="2022-05-01T04:43:57.374" v="497" actId="1076"/>
          <ac:spMkLst>
            <pc:docMk/>
            <pc:sldMk cId="2737564786" sldId="1544"/>
            <ac:spMk id="28" creationId="{E87F0079-DEDD-421B-8671-72B7415D8475}"/>
          </ac:spMkLst>
        </pc:spChg>
        <pc:spChg chg="mod">
          <ac:chgData name="築家　恵美" userId="f8a515c7-036c-4132-9fc2-097c41d54ccb" providerId="ADAL" clId="{6164B3F4-764D-4B0F-8956-69DA9E65C354}" dt="2022-05-01T04:43:52.136" v="496" actId="1076"/>
          <ac:spMkLst>
            <pc:docMk/>
            <pc:sldMk cId="2737564786" sldId="1544"/>
            <ac:spMk id="29" creationId="{684B3255-9DF0-47E5-AC29-22EAED094B5A}"/>
          </ac:spMkLst>
        </pc:spChg>
        <pc:spChg chg="mod">
          <ac:chgData name="築家　恵美" userId="f8a515c7-036c-4132-9fc2-097c41d54ccb" providerId="ADAL" clId="{6164B3F4-764D-4B0F-8956-69DA9E65C354}" dt="2022-05-01T04:42:32.629" v="463" actId="1035"/>
          <ac:spMkLst>
            <pc:docMk/>
            <pc:sldMk cId="2737564786" sldId="1544"/>
            <ac:spMk id="30" creationId="{9C37FE30-A9F9-4C46-9702-30DDE750778F}"/>
          </ac:spMkLst>
        </pc:spChg>
        <pc:spChg chg="mod">
          <ac:chgData name="築家　恵美" userId="f8a515c7-036c-4132-9fc2-097c41d54ccb" providerId="ADAL" clId="{6164B3F4-764D-4B0F-8956-69DA9E65C354}" dt="2022-05-01T02:53:19.318" v="258" actId="2711"/>
          <ac:spMkLst>
            <pc:docMk/>
            <pc:sldMk cId="2737564786" sldId="1544"/>
            <ac:spMk id="31" creationId="{F2D649BD-83BD-4C16-9649-E6805DE6755C}"/>
          </ac:spMkLst>
        </pc:spChg>
        <pc:spChg chg="mod">
          <ac:chgData name="築家　恵美" userId="f8a515c7-036c-4132-9fc2-097c41d54ccb" providerId="ADAL" clId="{6164B3F4-764D-4B0F-8956-69DA9E65C354}" dt="2022-05-01T04:42:32.629" v="463" actId="1035"/>
          <ac:spMkLst>
            <pc:docMk/>
            <pc:sldMk cId="2737564786" sldId="1544"/>
            <ac:spMk id="32" creationId="{77F9D426-B87A-48D2-AC64-EEAAEFB75C14}"/>
          </ac:spMkLst>
        </pc:spChg>
        <pc:spChg chg="mod">
          <ac:chgData name="築家　恵美" userId="f8a515c7-036c-4132-9fc2-097c41d54ccb" providerId="ADAL" clId="{6164B3F4-764D-4B0F-8956-69DA9E65C354}" dt="2022-05-01T02:53:19.318" v="258" actId="2711"/>
          <ac:spMkLst>
            <pc:docMk/>
            <pc:sldMk cId="2737564786" sldId="1544"/>
            <ac:spMk id="33" creationId="{DAA9116E-35F6-4632-A8BC-E1B4EA55F83A}"/>
          </ac:spMkLst>
        </pc:spChg>
        <pc:spChg chg="mod">
          <ac:chgData name="築家　恵美" userId="f8a515c7-036c-4132-9fc2-097c41d54ccb" providerId="ADAL" clId="{6164B3F4-764D-4B0F-8956-69DA9E65C354}" dt="2022-05-01T02:53:19.318" v="258" actId="2711"/>
          <ac:spMkLst>
            <pc:docMk/>
            <pc:sldMk cId="2737564786" sldId="1544"/>
            <ac:spMk id="34" creationId="{1A144062-55D0-49E9-A9C4-074C36101BC0}"/>
          </ac:spMkLst>
        </pc:spChg>
        <pc:spChg chg="mod">
          <ac:chgData name="築家　恵美" userId="f8a515c7-036c-4132-9fc2-097c41d54ccb" providerId="ADAL" clId="{6164B3F4-764D-4B0F-8956-69DA9E65C354}" dt="2022-05-01T02:53:19.318" v="258" actId="2711"/>
          <ac:spMkLst>
            <pc:docMk/>
            <pc:sldMk cId="2737564786" sldId="1544"/>
            <ac:spMk id="35" creationId="{11FE1617-F8C2-45BC-BEE9-EB606305D068}"/>
          </ac:spMkLst>
        </pc:spChg>
        <pc:spChg chg="mod">
          <ac:chgData name="築家　恵美" userId="f8a515c7-036c-4132-9fc2-097c41d54ccb" providerId="ADAL" clId="{6164B3F4-764D-4B0F-8956-69DA9E65C354}" dt="2022-05-01T02:53:19.318" v="258" actId="2711"/>
          <ac:spMkLst>
            <pc:docMk/>
            <pc:sldMk cId="2737564786" sldId="1544"/>
            <ac:spMk id="36" creationId="{8122FBE5-94BB-44A3-A972-B178007D01ED}"/>
          </ac:spMkLst>
        </pc:spChg>
        <pc:picChg chg="mod">
          <ac:chgData name="築家　恵美" userId="f8a515c7-036c-4132-9fc2-097c41d54ccb" providerId="ADAL" clId="{6164B3F4-764D-4B0F-8956-69DA9E65C354}" dt="2022-05-01T04:43:44.909" v="495" actId="1035"/>
          <ac:picMkLst>
            <pc:docMk/>
            <pc:sldMk cId="2737564786" sldId="1544"/>
            <ac:picMk id="5" creationId="{59AB4315-01AB-437A-B29D-9901264C81FB}"/>
          </ac:picMkLst>
        </pc:picChg>
        <pc:picChg chg="mod">
          <ac:chgData name="築家　恵美" userId="f8a515c7-036c-4132-9fc2-097c41d54ccb" providerId="ADAL" clId="{6164B3F4-764D-4B0F-8956-69DA9E65C354}" dt="2022-05-01T04:43:44.909" v="495" actId="1035"/>
          <ac:picMkLst>
            <pc:docMk/>
            <pc:sldMk cId="2737564786" sldId="1544"/>
            <ac:picMk id="6" creationId="{E84D135F-2565-4B9B-8977-75E4F3088D15}"/>
          </ac:picMkLst>
        </pc:picChg>
        <pc:picChg chg="mod">
          <ac:chgData name="築家　恵美" userId="f8a515c7-036c-4132-9fc2-097c41d54ccb" providerId="ADAL" clId="{6164B3F4-764D-4B0F-8956-69DA9E65C354}" dt="2022-05-01T04:42:32.629" v="463" actId="1035"/>
          <ac:picMkLst>
            <pc:docMk/>
            <pc:sldMk cId="2737564786" sldId="1544"/>
            <ac:picMk id="7" creationId="{A58F503C-89E5-418C-BB21-6F282F5ECB9E}"/>
          </ac:picMkLst>
        </pc:picChg>
        <pc:picChg chg="mod">
          <ac:chgData name="築家　恵美" userId="f8a515c7-036c-4132-9fc2-097c41d54ccb" providerId="ADAL" clId="{6164B3F4-764D-4B0F-8956-69DA9E65C354}" dt="2022-05-01T04:42:32.629" v="463" actId="1035"/>
          <ac:picMkLst>
            <pc:docMk/>
            <pc:sldMk cId="2737564786" sldId="1544"/>
            <ac:picMk id="13" creationId="{70026DAB-78A9-4C96-B357-439813CDC28E}"/>
          </ac:picMkLst>
        </pc:picChg>
        <pc:cxnChg chg="mod">
          <ac:chgData name="築家　恵美" userId="f8a515c7-036c-4132-9fc2-097c41d54ccb" providerId="ADAL" clId="{6164B3F4-764D-4B0F-8956-69DA9E65C354}" dt="2022-05-01T04:43:44.909" v="495" actId="1035"/>
          <ac:cxnSpMkLst>
            <pc:docMk/>
            <pc:sldMk cId="2737564786" sldId="1544"/>
            <ac:cxnSpMk id="12" creationId="{266CDAD2-3712-4213-B697-20E4771F911D}"/>
          </ac:cxnSpMkLst>
        </pc:cxnChg>
        <pc:cxnChg chg="mod">
          <ac:chgData name="築家　恵美" userId="f8a515c7-036c-4132-9fc2-097c41d54ccb" providerId="ADAL" clId="{6164B3F4-764D-4B0F-8956-69DA9E65C354}" dt="2022-05-01T04:43:44.909" v="495" actId="1035"/>
          <ac:cxnSpMkLst>
            <pc:docMk/>
            <pc:sldMk cId="2737564786" sldId="1544"/>
            <ac:cxnSpMk id="14" creationId="{03365C0D-930B-401B-BA91-A1BC730C08A3}"/>
          </ac:cxnSpMkLst>
        </pc:cxnChg>
        <pc:cxnChg chg="mod">
          <ac:chgData name="築家　恵美" userId="f8a515c7-036c-4132-9fc2-097c41d54ccb" providerId="ADAL" clId="{6164B3F4-764D-4B0F-8956-69DA9E65C354}" dt="2022-05-01T04:42:32.629" v="463" actId="1035"/>
          <ac:cxnSpMkLst>
            <pc:docMk/>
            <pc:sldMk cId="2737564786" sldId="1544"/>
            <ac:cxnSpMk id="15" creationId="{94472C14-F3A9-40A8-B9C9-EA7026410631}"/>
          </ac:cxnSpMkLst>
        </pc:cxnChg>
        <pc:cxnChg chg="mod">
          <ac:chgData name="築家　恵美" userId="f8a515c7-036c-4132-9fc2-097c41d54ccb" providerId="ADAL" clId="{6164B3F4-764D-4B0F-8956-69DA9E65C354}" dt="2022-05-01T04:42:32.629" v="463" actId="1035"/>
          <ac:cxnSpMkLst>
            <pc:docMk/>
            <pc:sldMk cId="2737564786" sldId="1544"/>
            <ac:cxnSpMk id="16" creationId="{17B81A3E-20A0-433E-942E-EDA82C0F5CC7}"/>
          </ac:cxnSpMkLst>
        </pc:cxnChg>
        <pc:cxnChg chg="mod">
          <ac:chgData name="築家　恵美" userId="f8a515c7-036c-4132-9fc2-097c41d54ccb" providerId="ADAL" clId="{6164B3F4-764D-4B0F-8956-69DA9E65C354}" dt="2022-05-01T04:43:44.909" v="495" actId="1035"/>
          <ac:cxnSpMkLst>
            <pc:docMk/>
            <pc:sldMk cId="2737564786" sldId="1544"/>
            <ac:cxnSpMk id="17" creationId="{30B8C6A5-90C9-4F90-B9D6-9A556323C067}"/>
          </ac:cxnSpMkLst>
        </pc:cxnChg>
        <pc:cxnChg chg="mod">
          <ac:chgData name="築家　恵美" userId="f8a515c7-036c-4132-9fc2-097c41d54ccb" providerId="ADAL" clId="{6164B3F4-764D-4B0F-8956-69DA9E65C354}" dt="2022-05-01T04:43:44.909" v="495" actId="1035"/>
          <ac:cxnSpMkLst>
            <pc:docMk/>
            <pc:sldMk cId="2737564786" sldId="1544"/>
            <ac:cxnSpMk id="18" creationId="{9A2E005D-B84B-4019-A404-E2D47BF0DBEF}"/>
          </ac:cxnSpMkLst>
        </pc:cxnChg>
        <pc:cxnChg chg="mod">
          <ac:chgData name="築家　恵美" userId="f8a515c7-036c-4132-9fc2-097c41d54ccb" providerId="ADAL" clId="{6164B3F4-764D-4B0F-8956-69DA9E65C354}" dt="2022-05-01T04:42:32.629" v="463" actId="1035"/>
          <ac:cxnSpMkLst>
            <pc:docMk/>
            <pc:sldMk cId="2737564786" sldId="1544"/>
            <ac:cxnSpMk id="22" creationId="{9A255FB2-CB5B-4219-B93A-78AF46D1EE6C}"/>
          </ac:cxnSpMkLst>
        </pc:cxnChg>
      </pc:sldChg>
      <pc:sldChg chg="addSp modSp mod modNotesTx">
        <pc:chgData name="築家　恵美" userId="f8a515c7-036c-4132-9fc2-097c41d54ccb" providerId="ADAL" clId="{6164B3F4-764D-4B0F-8956-69DA9E65C354}" dt="2022-05-01T06:12:28.532" v="590" actId="554"/>
        <pc:sldMkLst>
          <pc:docMk/>
          <pc:sldMk cId="2656985132" sldId="1545"/>
        </pc:sldMkLst>
        <pc:spChg chg="mod">
          <ac:chgData name="築家　恵美" userId="f8a515c7-036c-4132-9fc2-097c41d54ccb" providerId="ADAL" clId="{6164B3F4-764D-4B0F-8956-69DA9E65C354}" dt="2022-05-01T06:11:56.528" v="547" actId="1076"/>
          <ac:spMkLst>
            <pc:docMk/>
            <pc:sldMk cId="2656985132" sldId="1545"/>
            <ac:spMk id="7" creationId="{42BD6D29-446B-4228-AE46-2D01FC226AD6}"/>
          </ac:spMkLst>
        </pc:spChg>
        <pc:spChg chg="mod">
          <ac:chgData name="築家　恵美" userId="f8a515c7-036c-4132-9fc2-097c41d54ccb" providerId="ADAL" clId="{6164B3F4-764D-4B0F-8956-69DA9E65C354}" dt="2022-05-01T06:12:09.129" v="553" actId="1037"/>
          <ac:spMkLst>
            <pc:docMk/>
            <pc:sldMk cId="2656985132" sldId="1545"/>
            <ac:spMk id="8" creationId="{9F81EEDC-66A2-4329-98F8-FDA379229655}"/>
          </ac:spMkLst>
        </pc:spChg>
        <pc:spChg chg="mod">
          <ac:chgData name="築家　恵美" userId="f8a515c7-036c-4132-9fc2-097c41d54ccb" providerId="ADAL" clId="{6164B3F4-764D-4B0F-8956-69DA9E65C354}" dt="2022-05-01T06:11:48.038" v="545" actId="1076"/>
          <ac:spMkLst>
            <pc:docMk/>
            <pc:sldMk cId="2656985132" sldId="1545"/>
            <ac:spMk id="9" creationId="{697954D4-0455-43E7-A767-DF072C96BDEB}"/>
          </ac:spMkLst>
        </pc:spChg>
        <pc:spChg chg="mod">
          <ac:chgData name="築家　恵美" userId="f8a515c7-036c-4132-9fc2-097c41d54ccb" providerId="ADAL" clId="{6164B3F4-764D-4B0F-8956-69DA9E65C354}" dt="2022-05-01T06:11:53.468" v="546" actId="1076"/>
          <ac:spMkLst>
            <pc:docMk/>
            <pc:sldMk cId="2656985132" sldId="1545"/>
            <ac:spMk id="10" creationId="{57D07C43-9C2E-43BC-8926-276B9D9FBDF0}"/>
          </ac:spMkLst>
        </pc:spChg>
        <pc:spChg chg="mod">
          <ac:chgData name="築家　恵美" userId="f8a515c7-036c-4132-9fc2-097c41d54ccb" providerId="ADAL" clId="{6164B3F4-764D-4B0F-8956-69DA9E65C354}" dt="2022-05-01T06:11:36.849" v="542" actId="1076"/>
          <ac:spMkLst>
            <pc:docMk/>
            <pc:sldMk cId="2656985132" sldId="1545"/>
            <ac:spMk id="11" creationId="{30B8F9C0-7C4F-4155-9083-D720B6E5A969}"/>
          </ac:spMkLst>
        </pc:spChg>
        <pc:spChg chg="mod">
          <ac:chgData name="築家　恵美" userId="f8a515c7-036c-4132-9fc2-097c41d54ccb" providerId="ADAL" clId="{6164B3F4-764D-4B0F-8956-69DA9E65C354}" dt="2022-05-01T06:11:42.146" v="544" actId="1076"/>
          <ac:spMkLst>
            <pc:docMk/>
            <pc:sldMk cId="2656985132" sldId="1545"/>
            <ac:spMk id="12" creationId="{2ACB7089-FD64-4D49-9AE4-8CA6F0C353D7}"/>
          </ac:spMkLst>
        </pc:spChg>
        <pc:spChg chg="add mod">
          <ac:chgData name="築家　恵美" userId="f8a515c7-036c-4132-9fc2-097c41d54ccb" providerId="ADAL" clId="{6164B3F4-764D-4B0F-8956-69DA9E65C354}" dt="2022-05-01T06:12:28.532" v="590" actId="554"/>
          <ac:spMkLst>
            <pc:docMk/>
            <pc:sldMk cId="2656985132" sldId="1545"/>
            <ac:spMk id="13" creationId="{92AE953E-F678-4595-B14E-4E30BEAC5994}"/>
          </ac:spMkLst>
        </pc:spChg>
        <pc:spChg chg="add mod">
          <ac:chgData name="築家　恵美" userId="f8a515c7-036c-4132-9fc2-097c41d54ccb" providerId="ADAL" clId="{6164B3F4-764D-4B0F-8956-69DA9E65C354}" dt="2022-05-01T06:12:28.532" v="590" actId="554"/>
          <ac:spMkLst>
            <pc:docMk/>
            <pc:sldMk cId="2656985132" sldId="1545"/>
            <ac:spMk id="14" creationId="{22BCE159-5115-4B9E-A592-7A8A9C8537FE}"/>
          </ac:spMkLst>
        </pc:spChg>
        <pc:graphicFrameChg chg="mod">
          <ac:chgData name="築家　恵美" userId="f8a515c7-036c-4132-9fc2-097c41d54ccb" providerId="ADAL" clId="{6164B3F4-764D-4B0F-8956-69DA9E65C354}" dt="2022-05-01T06:10:52.598" v="539" actId="14100"/>
          <ac:graphicFrameMkLst>
            <pc:docMk/>
            <pc:sldMk cId="2656985132" sldId="1545"/>
            <ac:graphicFrameMk id="4" creationId="{F2C967B2-17C4-452C-9CB3-B2E11D88C0BE}"/>
          </ac:graphicFrameMkLst>
        </pc:graphicFrameChg>
        <pc:graphicFrameChg chg="mod">
          <ac:chgData name="築家　恵美" userId="f8a515c7-036c-4132-9fc2-097c41d54ccb" providerId="ADAL" clId="{6164B3F4-764D-4B0F-8956-69DA9E65C354}" dt="2022-05-01T06:10:52.598" v="539" actId="14100"/>
          <ac:graphicFrameMkLst>
            <pc:docMk/>
            <pc:sldMk cId="2656985132" sldId="1545"/>
            <ac:graphicFrameMk id="5" creationId="{F2C967B2-17C4-452C-9CB3-B2E11D88C0BE}"/>
          </ac:graphicFrameMkLst>
        </pc:graphicFrameChg>
      </pc:sldChg>
      <pc:sldChg chg="modSp del mod modNotesTx">
        <pc:chgData name="築家　恵美" userId="f8a515c7-036c-4132-9fc2-097c41d54ccb" providerId="ADAL" clId="{6164B3F4-764D-4B0F-8956-69DA9E65C354}" dt="2022-05-06T04:52:31.846" v="593" actId="47"/>
        <pc:sldMkLst>
          <pc:docMk/>
          <pc:sldMk cId="2795708836" sldId="1546"/>
        </pc:sldMkLst>
        <pc:spChg chg="mod">
          <ac:chgData name="築家　恵美" userId="f8a515c7-036c-4132-9fc2-097c41d54ccb" providerId="ADAL" clId="{6164B3F4-764D-4B0F-8956-69DA9E65C354}" dt="2022-05-01T02:51:41.978" v="238" actId="1076"/>
          <ac:spMkLst>
            <pc:docMk/>
            <pc:sldMk cId="2795708836" sldId="1546"/>
            <ac:spMk id="4" creationId="{2E06A803-9CA0-4D84-8AE7-3C00140A94E9}"/>
          </ac:spMkLst>
        </pc:spChg>
        <pc:spChg chg="mod">
          <ac:chgData name="築家　恵美" userId="f8a515c7-036c-4132-9fc2-097c41d54ccb" providerId="ADAL" clId="{6164B3F4-764D-4B0F-8956-69DA9E65C354}" dt="2022-05-01T02:51:16.513" v="235" actId="255"/>
          <ac:spMkLst>
            <pc:docMk/>
            <pc:sldMk cId="2795708836" sldId="1546"/>
            <ac:spMk id="7" creationId="{5E76C1B8-0381-4750-B60C-E35A0F16546A}"/>
          </ac:spMkLst>
        </pc:spChg>
        <pc:spChg chg="mod">
          <ac:chgData name="築家　恵美" userId="f8a515c7-036c-4132-9fc2-097c41d54ccb" providerId="ADAL" clId="{6164B3F4-764D-4B0F-8956-69DA9E65C354}" dt="2022-05-01T02:51:50.345" v="239" actId="1076"/>
          <ac:spMkLst>
            <pc:docMk/>
            <pc:sldMk cId="2795708836" sldId="1546"/>
            <ac:spMk id="13" creationId="{0D1FDBAE-E7C8-4821-BB9E-21F43D7D0669}"/>
          </ac:spMkLst>
        </pc:spChg>
        <pc:graphicFrameChg chg="mod">
          <ac:chgData name="築家　恵美" userId="f8a515c7-036c-4132-9fc2-097c41d54ccb" providerId="ADAL" clId="{6164B3F4-764D-4B0F-8956-69DA9E65C354}" dt="2022-05-01T02:51:29.504" v="237" actId="2711"/>
          <ac:graphicFrameMkLst>
            <pc:docMk/>
            <pc:sldMk cId="2795708836" sldId="1546"/>
            <ac:graphicFrameMk id="2" creationId="{3166DEDD-1A1C-4AD6-BC5C-5A2A720B9DCC}"/>
          </ac:graphicFrameMkLst>
        </pc:graphicFrameChg>
      </pc:sldChg>
      <pc:sldChg chg="modSp mod modNotesTx">
        <pc:chgData name="築家　恵美" userId="f8a515c7-036c-4132-9fc2-097c41d54ccb" providerId="ADAL" clId="{6164B3F4-764D-4B0F-8956-69DA9E65C354}" dt="2022-05-06T04:52:51.543" v="595" actId="554"/>
        <pc:sldMkLst>
          <pc:docMk/>
          <pc:sldMk cId="2851950515" sldId="1547"/>
        </pc:sldMkLst>
        <pc:spChg chg="mod">
          <ac:chgData name="築家　恵美" userId="f8a515c7-036c-4132-9fc2-097c41d54ccb" providerId="ADAL" clId="{6164B3F4-764D-4B0F-8956-69DA9E65C354}" dt="2022-05-01T06:12:39.154" v="591" actId="554"/>
          <ac:spMkLst>
            <pc:docMk/>
            <pc:sldMk cId="2851950515" sldId="1547"/>
            <ac:spMk id="6" creationId="{55F8B415-BE9F-40E3-AF23-6EDD90F595EA}"/>
          </ac:spMkLst>
        </pc:spChg>
        <pc:spChg chg="mod">
          <ac:chgData name="築家　恵美" userId="f8a515c7-036c-4132-9fc2-097c41d54ccb" providerId="ADAL" clId="{6164B3F4-764D-4B0F-8956-69DA9E65C354}" dt="2022-05-01T06:09:00.008" v="527" actId="1036"/>
          <ac:spMkLst>
            <pc:docMk/>
            <pc:sldMk cId="2851950515" sldId="1547"/>
            <ac:spMk id="7" creationId="{37F7D5CF-F508-41E9-9F90-E00439CC1A4F}"/>
          </ac:spMkLst>
        </pc:spChg>
        <pc:spChg chg="mod">
          <ac:chgData name="築家　恵美" userId="f8a515c7-036c-4132-9fc2-097c41d54ccb" providerId="ADAL" clId="{6164B3F4-764D-4B0F-8956-69DA9E65C354}" dt="2022-05-01T06:09:37.713" v="534" actId="1076"/>
          <ac:spMkLst>
            <pc:docMk/>
            <pc:sldMk cId="2851950515" sldId="1547"/>
            <ac:spMk id="8" creationId="{28D50EB3-9B78-4649-9768-8DC770C7B018}"/>
          </ac:spMkLst>
        </pc:spChg>
        <pc:spChg chg="mod">
          <ac:chgData name="築家　恵美" userId="f8a515c7-036c-4132-9fc2-097c41d54ccb" providerId="ADAL" clId="{6164B3F4-764D-4B0F-8956-69DA9E65C354}" dt="2022-05-01T06:09:29.262" v="533" actId="1076"/>
          <ac:spMkLst>
            <pc:docMk/>
            <pc:sldMk cId="2851950515" sldId="1547"/>
            <ac:spMk id="9" creationId="{7B1777C7-5112-44A2-9F2B-5C50DDD4B3DA}"/>
          </ac:spMkLst>
        </pc:spChg>
        <pc:spChg chg="mod">
          <ac:chgData name="築家　恵美" userId="f8a515c7-036c-4132-9fc2-097c41d54ccb" providerId="ADAL" clId="{6164B3F4-764D-4B0F-8956-69DA9E65C354}" dt="2022-05-01T06:12:39.154" v="591" actId="554"/>
          <ac:spMkLst>
            <pc:docMk/>
            <pc:sldMk cId="2851950515" sldId="1547"/>
            <ac:spMk id="10" creationId="{7A3DBBF8-AE95-4DC1-A405-7F893F4609FF}"/>
          </ac:spMkLst>
        </pc:spChg>
        <pc:spChg chg="mod">
          <ac:chgData name="築家　恵美" userId="f8a515c7-036c-4132-9fc2-097c41d54ccb" providerId="ADAL" clId="{6164B3F4-764D-4B0F-8956-69DA9E65C354}" dt="2022-05-01T06:08:42.178" v="522" actId="1076"/>
          <ac:spMkLst>
            <pc:docMk/>
            <pc:sldMk cId="2851950515" sldId="1547"/>
            <ac:spMk id="11" creationId="{56ED5E6C-86B9-4BCB-B208-A58B16C77D52}"/>
          </ac:spMkLst>
        </pc:spChg>
        <pc:spChg chg="mod">
          <ac:chgData name="築家　恵美" userId="f8a515c7-036c-4132-9fc2-097c41d54ccb" providerId="ADAL" clId="{6164B3F4-764D-4B0F-8956-69DA9E65C354}" dt="2022-05-01T06:08:17.214" v="518" actId="12788"/>
          <ac:spMkLst>
            <pc:docMk/>
            <pc:sldMk cId="2851950515" sldId="1547"/>
            <ac:spMk id="12" creationId="{443B432C-E7EF-43E1-A922-96AF55CE5CCA}"/>
          </ac:spMkLst>
        </pc:spChg>
        <pc:spChg chg="mod">
          <ac:chgData name="築家　恵美" userId="f8a515c7-036c-4132-9fc2-097c41d54ccb" providerId="ADAL" clId="{6164B3F4-764D-4B0F-8956-69DA9E65C354}" dt="2022-05-01T06:08:29.864" v="520" actId="1076"/>
          <ac:spMkLst>
            <pc:docMk/>
            <pc:sldMk cId="2851950515" sldId="1547"/>
            <ac:spMk id="13" creationId="{21696853-FAF2-492B-A959-96D21B782645}"/>
          </ac:spMkLst>
        </pc:spChg>
        <pc:spChg chg="mod">
          <ac:chgData name="築家　恵美" userId="f8a515c7-036c-4132-9fc2-097c41d54ccb" providerId="ADAL" clId="{6164B3F4-764D-4B0F-8956-69DA9E65C354}" dt="2022-05-01T06:08:17.214" v="518" actId="12788"/>
          <ac:spMkLst>
            <pc:docMk/>
            <pc:sldMk cId="2851950515" sldId="1547"/>
            <ac:spMk id="14" creationId="{2072F15C-001C-4DF3-BC33-361F2B8AD709}"/>
          </ac:spMkLst>
        </pc:spChg>
        <pc:spChg chg="mod">
          <ac:chgData name="築家　恵美" userId="f8a515c7-036c-4132-9fc2-097c41d54ccb" providerId="ADAL" clId="{6164B3F4-764D-4B0F-8956-69DA9E65C354}" dt="2022-05-01T06:09:12.157" v="529" actId="1076"/>
          <ac:spMkLst>
            <pc:docMk/>
            <pc:sldMk cId="2851950515" sldId="1547"/>
            <ac:spMk id="15" creationId="{7141E4D3-468E-4BA0-87E8-69CED0C3E111}"/>
          </ac:spMkLst>
        </pc:spChg>
        <pc:spChg chg="mod">
          <ac:chgData name="築家　恵美" userId="f8a515c7-036c-4132-9fc2-097c41d54ccb" providerId="ADAL" clId="{6164B3F4-764D-4B0F-8956-69DA9E65C354}" dt="2022-05-01T06:09:07.162" v="528" actId="1076"/>
          <ac:spMkLst>
            <pc:docMk/>
            <pc:sldMk cId="2851950515" sldId="1547"/>
            <ac:spMk id="16" creationId="{10F20B14-D218-483F-85B4-A04922286EB9}"/>
          </ac:spMkLst>
        </pc:spChg>
        <pc:spChg chg="mod">
          <ac:chgData name="築家　恵美" userId="f8a515c7-036c-4132-9fc2-097c41d54ccb" providerId="ADAL" clId="{6164B3F4-764D-4B0F-8956-69DA9E65C354}" dt="2022-05-01T06:09:17.601" v="530" actId="1076"/>
          <ac:spMkLst>
            <pc:docMk/>
            <pc:sldMk cId="2851950515" sldId="1547"/>
            <ac:spMk id="17" creationId="{5EFCC239-C17A-4E6B-8B2C-186D783DA2B1}"/>
          </ac:spMkLst>
        </pc:spChg>
        <pc:graphicFrameChg chg="mod">
          <ac:chgData name="築家　恵美" userId="f8a515c7-036c-4132-9fc2-097c41d54ccb" providerId="ADAL" clId="{6164B3F4-764D-4B0F-8956-69DA9E65C354}" dt="2022-05-01T06:07:48.672" v="513" actId="1076"/>
          <ac:graphicFrameMkLst>
            <pc:docMk/>
            <pc:sldMk cId="2851950515" sldId="1547"/>
            <ac:graphicFrameMk id="3" creationId="{F2C967B2-17C4-452C-9CB3-B2E11D88C0BE}"/>
          </ac:graphicFrameMkLst>
        </pc:graphicFrameChg>
        <pc:graphicFrameChg chg="mod">
          <ac:chgData name="築家　恵美" userId="f8a515c7-036c-4132-9fc2-097c41d54ccb" providerId="ADAL" clId="{6164B3F4-764D-4B0F-8956-69DA9E65C354}" dt="2022-05-06T04:52:51.543" v="595" actId="554"/>
          <ac:graphicFrameMkLst>
            <pc:docMk/>
            <pc:sldMk cId="2851950515" sldId="1547"/>
            <ac:graphicFrameMk id="4" creationId="{F2C967B2-17C4-452C-9CB3-B2E11D88C0BE}"/>
          </ac:graphicFrameMkLst>
        </pc:graphicFrameChg>
        <pc:graphicFrameChg chg="mod">
          <ac:chgData name="築家　恵美" userId="f8a515c7-036c-4132-9fc2-097c41d54ccb" providerId="ADAL" clId="{6164B3F4-764D-4B0F-8956-69DA9E65C354}" dt="2022-05-06T04:52:51.543" v="595" actId="554"/>
          <ac:graphicFrameMkLst>
            <pc:docMk/>
            <pc:sldMk cId="2851950515" sldId="1547"/>
            <ac:graphicFrameMk id="5" creationId="{F2C967B2-17C4-452C-9CB3-B2E11D88C0BE}"/>
          </ac:graphicFrameMkLst>
        </pc:graphicFrameChg>
      </pc:sldChg>
      <pc:sldChg chg="del">
        <pc:chgData name="築家　恵美" userId="f8a515c7-036c-4132-9fc2-097c41d54ccb" providerId="ADAL" clId="{6164B3F4-764D-4B0F-8956-69DA9E65C354}" dt="2022-05-06T04:52:31.846" v="593" actId="47"/>
        <pc:sldMkLst>
          <pc:docMk/>
          <pc:sldMk cId="3101292763" sldId="1548"/>
        </pc:sldMkLst>
      </pc:sldChg>
      <pc:sldChg chg="del">
        <pc:chgData name="築家　恵美" userId="f8a515c7-036c-4132-9fc2-097c41d54ccb" providerId="ADAL" clId="{6164B3F4-764D-4B0F-8956-69DA9E65C354}" dt="2022-05-06T04:52:35.439" v="594" actId="47"/>
        <pc:sldMkLst>
          <pc:docMk/>
          <pc:sldMk cId="12454413" sldId="1549"/>
        </pc:sldMkLst>
      </pc:sldChg>
      <pc:sldChg chg="del">
        <pc:chgData name="築家　恵美" userId="f8a515c7-036c-4132-9fc2-097c41d54ccb" providerId="ADAL" clId="{6164B3F4-764D-4B0F-8956-69DA9E65C354}" dt="2022-05-06T04:52:35.439" v="594" actId="47"/>
        <pc:sldMkLst>
          <pc:docMk/>
          <pc:sldMk cId="3625042175" sldId="1550"/>
        </pc:sldMkLst>
      </pc:sldChg>
      <pc:sldChg chg="modSp del mod modNotesTx">
        <pc:chgData name="築家　恵美" userId="f8a515c7-036c-4132-9fc2-097c41d54ccb" providerId="ADAL" clId="{6164B3F4-764D-4B0F-8956-69DA9E65C354}" dt="2022-05-06T04:52:31.846" v="593" actId="47"/>
        <pc:sldMkLst>
          <pc:docMk/>
          <pc:sldMk cId="1992467510" sldId="1551"/>
        </pc:sldMkLst>
        <pc:spChg chg="mod">
          <ac:chgData name="築家　恵美" userId="f8a515c7-036c-4132-9fc2-097c41d54ccb" providerId="ADAL" clId="{6164B3F4-764D-4B0F-8956-69DA9E65C354}" dt="2022-05-01T01:56:06.108" v="93" actId="1037"/>
          <ac:spMkLst>
            <pc:docMk/>
            <pc:sldMk cId="1992467510" sldId="1551"/>
            <ac:spMk id="2" creationId="{71B7F480-A674-4D40-A9D9-0097F6FD8BA1}"/>
          </ac:spMkLst>
        </pc:spChg>
        <pc:spChg chg="mod">
          <ac:chgData name="築家　恵美" userId="f8a515c7-036c-4132-9fc2-097c41d54ccb" providerId="ADAL" clId="{6164B3F4-764D-4B0F-8956-69DA9E65C354}" dt="2022-05-01T01:56:09.943" v="95" actId="1037"/>
          <ac:spMkLst>
            <pc:docMk/>
            <pc:sldMk cId="1992467510" sldId="1551"/>
            <ac:spMk id="3" creationId="{5AAF28F2-6F7D-481F-A027-2E1224192A93}"/>
          </ac:spMkLst>
        </pc:spChg>
        <pc:spChg chg="mod">
          <ac:chgData name="築家　恵美" userId="f8a515c7-036c-4132-9fc2-097c41d54ccb" providerId="ADAL" clId="{6164B3F4-764D-4B0F-8956-69DA9E65C354}" dt="2022-05-01T01:54:54.518" v="12" actId="1036"/>
          <ac:spMkLst>
            <pc:docMk/>
            <pc:sldMk cId="1992467510" sldId="1551"/>
            <ac:spMk id="4" creationId="{27D4127C-B955-4360-B442-0F9925CA6CFA}"/>
          </ac:spMkLst>
        </pc:spChg>
        <pc:spChg chg="mod">
          <ac:chgData name="築家　恵美" userId="f8a515c7-036c-4132-9fc2-097c41d54ccb" providerId="ADAL" clId="{6164B3F4-764D-4B0F-8956-69DA9E65C354}" dt="2022-05-01T01:54:59.427" v="15" actId="1035"/>
          <ac:spMkLst>
            <pc:docMk/>
            <pc:sldMk cId="1992467510" sldId="1551"/>
            <ac:spMk id="5" creationId="{AE8C8A7A-66E7-48C4-BEE7-AF5621784AF5}"/>
          </ac:spMkLst>
        </pc:spChg>
        <pc:spChg chg="mod">
          <ac:chgData name="築家　恵美" userId="f8a515c7-036c-4132-9fc2-097c41d54ccb" providerId="ADAL" clId="{6164B3F4-764D-4B0F-8956-69DA9E65C354}" dt="2022-05-01T01:55:25.171" v="59" actId="1038"/>
          <ac:spMkLst>
            <pc:docMk/>
            <pc:sldMk cId="1992467510" sldId="1551"/>
            <ac:spMk id="6" creationId="{5EE7BD52-E269-48A7-8B7F-816E9CADADAD}"/>
          </ac:spMkLst>
        </pc:spChg>
        <pc:spChg chg="mod">
          <ac:chgData name="築家　恵美" userId="f8a515c7-036c-4132-9fc2-097c41d54ccb" providerId="ADAL" clId="{6164B3F4-764D-4B0F-8956-69DA9E65C354}" dt="2022-05-01T01:55:12.222" v="25" actId="1035"/>
          <ac:spMkLst>
            <pc:docMk/>
            <pc:sldMk cId="1992467510" sldId="1551"/>
            <ac:spMk id="7" creationId="{B490BF6A-E72B-4207-BB13-7D8C67D60184}"/>
          </ac:spMkLst>
        </pc:spChg>
        <pc:spChg chg="mod">
          <ac:chgData name="築家　恵美" userId="f8a515c7-036c-4132-9fc2-097c41d54ccb" providerId="ADAL" clId="{6164B3F4-764D-4B0F-8956-69DA9E65C354}" dt="2022-05-01T01:56:06.108" v="93" actId="1037"/>
          <ac:spMkLst>
            <pc:docMk/>
            <pc:sldMk cId="1992467510" sldId="1551"/>
            <ac:spMk id="8" creationId="{0EA92D96-1438-4E7E-B423-4BC09C7960B8}"/>
          </ac:spMkLst>
        </pc:spChg>
        <pc:spChg chg="mod">
          <ac:chgData name="築家　恵美" userId="f8a515c7-036c-4132-9fc2-097c41d54ccb" providerId="ADAL" clId="{6164B3F4-764D-4B0F-8956-69DA9E65C354}" dt="2022-05-01T01:56:09.943" v="95" actId="1037"/>
          <ac:spMkLst>
            <pc:docMk/>
            <pc:sldMk cId="1992467510" sldId="1551"/>
            <ac:spMk id="9" creationId="{FD8030E1-B02C-4664-B64A-F58F89CA874F}"/>
          </ac:spMkLst>
        </pc:spChg>
        <pc:graphicFrameChg chg="mod">
          <ac:chgData name="築家　恵美" userId="f8a515c7-036c-4132-9fc2-097c41d54ccb" providerId="ADAL" clId="{6164B3F4-764D-4B0F-8956-69DA9E65C354}" dt="2022-05-01T01:54:04.496" v="1" actId="1076"/>
          <ac:graphicFrameMkLst>
            <pc:docMk/>
            <pc:sldMk cId="1992467510" sldId="1551"/>
            <ac:graphicFrameMk id="10" creationId="{EF7BB7D3-E073-480E-88D9-60BB107875F1}"/>
          </ac:graphicFrameMkLst>
        </pc:graphicFrameChg>
        <pc:graphicFrameChg chg="mod">
          <ac:chgData name="築家　恵美" userId="f8a515c7-036c-4132-9fc2-097c41d54ccb" providerId="ADAL" clId="{6164B3F4-764D-4B0F-8956-69DA9E65C354}" dt="2022-05-01T01:54:15.825" v="2" actId="1076"/>
          <ac:graphicFrameMkLst>
            <pc:docMk/>
            <pc:sldMk cId="1992467510" sldId="1551"/>
            <ac:graphicFrameMk id="11" creationId="{34395CA2-0E34-471E-B763-11F858A291E8}"/>
          </ac:graphicFrameMkLst>
        </pc:graphicFrameChg>
      </pc:sldChg>
    </pc:docChg>
  </pc:docChgLst>
  <pc:docChgLst>
    <pc:chgData name="築家　恵美" userId="f8a515c7-036c-4132-9fc2-097c41d54ccb" providerId="ADAL" clId="{7B57AEAE-1156-439D-A01B-B371E6D6D023}"/>
    <pc:docChg chg="modSld">
      <pc:chgData name="築家　恵美" userId="f8a515c7-036c-4132-9fc2-097c41d54ccb" providerId="ADAL" clId="{7B57AEAE-1156-439D-A01B-B371E6D6D023}" dt="2023-06-09T03:15:51.677" v="16" actId="20577"/>
      <pc:docMkLst>
        <pc:docMk/>
      </pc:docMkLst>
      <pc:sldChg chg="modSp mod">
        <pc:chgData name="築家　恵美" userId="f8a515c7-036c-4132-9fc2-097c41d54ccb" providerId="ADAL" clId="{7B57AEAE-1156-439D-A01B-B371E6D6D023}" dt="2023-06-09T03:15:51.677" v="16" actId="20577"/>
        <pc:sldMkLst>
          <pc:docMk/>
          <pc:sldMk cId="2851950515" sldId="1547"/>
        </pc:sldMkLst>
        <pc:spChg chg="mod">
          <ac:chgData name="築家　恵美" userId="f8a515c7-036c-4132-9fc2-097c41d54ccb" providerId="ADAL" clId="{7B57AEAE-1156-439D-A01B-B371E6D6D023}" dt="2023-06-09T03:15:47.697" v="15" actId="20577"/>
          <ac:spMkLst>
            <pc:docMk/>
            <pc:sldMk cId="2851950515" sldId="1547"/>
            <ac:spMk id="15" creationId="{7141E4D3-468E-4BA0-87E8-69CED0C3E111}"/>
          </ac:spMkLst>
        </pc:spChg>
        <pc:spChg chg="mod">
          <ac:chgData name="築家　恵美" userId="f8a515c7-036c-4132-9fc2-097c41d54ccb" providerId="ADAL" clId="{7B57AEAE-1156-439D-A01B-B371E6D6D023}" dt="2023-06-09T03:15:42.518" v="11" actId="20577"/>
          <ac:spMkLst>
            <pc:docMk/>
            <pc:sldMk cId="2851950515" sldId="1547"/>
            <ac:spMk id="16" creationId="{10F20B14-D218-483F-85B4-A04922286EB9}"/>
          </ac:spMkLst>
        </pc:spChg>
        <pc:spChg chg="mod">
          <ac:chgData name="築家　恵美" userId="f8a515c7-036c-4132-9fc2-097c41d54ccb" providerId="ADAL" clId="{7B57AEAE-1156-439D-A01B-B371E6D6D023}" dt="2023-06-09T03:15:51.677" v="16" actId="20577"/>
          <ac:spMkLst>
            <pc:docMk/>
            <pc:sldMk cId="2851950515" sldId="1547"/>
            <ac:spMk id="17" creationId="{5EFCC239-C17A-4E6B-8B2C-186D783DA2B1}"/>
          </ac:spMkLst>
        </pc:spChg>
      </pc:sldChg>
    </pc:docChg>
  </pc:docChgLst>
  <pc:docChgLst>
    <pc:chgData name="佐伯　吉弘" userId="S::iop890@hiroshima-u.ac.jp::c48215f7-a175-419d-95e9-d9045df60879" providerId="AD" clId="Web-{BF904567-1496-26FD-59B2-275298C438AB}"/>
    <pc:docChg chg="modSld">
      <pc:chgData name="佐伯　吉弘" userId="S::iop890@hiroshima-u.ac.jp::c48215f7-a175-419d-95e9-d9045df60879" providerId="AD" clId="Web-{BF904567-1496-26FD-59B2-275298C438AB}" dt="2023-08-05T06:18:47.697" v="11" actId="20577"/>
      <pc:docMkLst>
        <pc:docMk/>
      </pc:docMkLst>
      <pc:sldChg chg="modSp">
        <pc:chgData name="佐伯　吉弘" userId="S::iop890@hiroshima-u.ac.jp::c48215f7-a175-419d-95e9-d9045df60879" providerId="AD" clId="Web-{BF904567-1496-26FD-59B2-275298C438AB}" dt="2023-08-05T06:18:47.697" v="11" actId="20577"/>
        <pc:sldMkLst>
          <pc:docMk/>
          <pc:sldMk cId="2851950515" sldId="1547"/>
        </pc:sldMkLst>
        <pc:spChg chg="mod">
          <ac:chgData name="佐伯　吉弘" userId="S::iop890@hiroshima-u.ac.jp::c48215f7-a175-419d-95e9-d9045df60879" providerId="AD" clId="Web-{BF904567-1496-26FD-59B2-275298C438AB}" dt="2023-08-05T06:18:47.385" v="0" actId="20577"/>
          <ac:spMkLst>
            <pc:docMk/>
            <pc:sldMk cId="2851950515" sldId="1547"/>
            <ac:spMk id="6" creationId="{55F8B415-BE9F-40E3-AF23-6EDD90F595EA}"/>
          </ac:spMkLst>
        </pc:spChg>
        <pc:spChg chg="mod">
          <ac:chgData name="佐伯　吉弘" userId="S::iop890@hiroshima-u.ac.jp::c48215f7-a175-419d-95e9-d9045df60879" providerId="AD" clId="Web-{BF904567-1496-26FD-59B2-275298C438AB}" dt="2023-08-05T06:18:47.416" v="1" actId="20577"/>
          <ac:spMkLst>
            <pc:docMk/>
            <pc:sldMk cId="2851950515" sldId="1547"/>
            <ac:spMk id="7" creationId="{37F7D5CF-F508-41E9-9F90-E00439CC1A4F}"/>
          </ac:spMkLst>
        </pc:spChg>
        <pc:spChg chg="mod">
          <ac:chgData name="佐伯　吉弘" userId="S::iop890@hiroshima-u.ac.jp::c48215f7-a175-419d-95e9-d9045df60879" providerId="AD" clId="Web-{BF904567-1496-26FD-59B2-275298C438AB}" dt="2023-08-05T06:18:47.447" v="2" actId="20577"/>
          <ac:spMkLst>
            <pc:docMk/>
            <pc:sldMk cId="2851950515" sldId="1547"/>
            <ac:spMk id="8" creationId="{28D50EB3-9B78-4649-9768-8DC770C7B018}"/>
          </ac:spMkLst>
        </pc:spChg>
        <pc:spChg chg="mod">
          <ac:chgData name="佐伯　吉弘" userId="S::iop890@hiroshima-u.ac.jp::c48215f7-a175-419d-95e9-d9045df60879" providerId="AD" clId="Web-{BF904567-1496-26FD-59B2-275298C438AB}" dt="2023-08-05T06:18:47.463" v="3" actId="20577"/>
          <ac:spMkLst>
            <pc:docMk/>
            <pc:sldMk cId="2851950515" sldId="1547"/>
            <ac:spMk id="9" creationId="{7B1777C7-5112-44A2-9F2B-5C50DDD4B3DA}"/>
          </ac:spMkLst>
        </pc:spChg>
        <pc:spChg chg="mod">
          <ac:chgData name="佐伯　吉弘" userId="S::iop890@hiroshima-u.ac.jp::c48215f7-a175-419d-95e9-d9045df60879" providerId="AD" clId="Web-{BF904567-1496-26FD-59B2-275298C438AB}" dt="2023-08-05T06:18:47.510" v="4" actId="20577"/>
          <ac:spMkLst>
            <pc:docMk/>
            <pc:sldMk cId="2851950515" sldId="1547"/>
            <ac:spMk id="10" creationId="{7A3DBBF8-AE95-4DC1-A405-7F893F4609FF}"/>
          </ac:spMkLst>
        </pc:spChg>
        <pc:spChg chg="mod">
          <ac:chgData name="佐伯　吉弘" userId="S::iop890@hiroshima-u.ac.jp::c48215f7-a175-419d-95e9-d9045df60879" providerId="AD" clId="Web-{BF904567-1496-26FD-59B2-275298C438AB}" dt="2023-08-05T06:18:47.541" v="5" actId="20577"/>
          <ac:spMkLst>
            <pc:docMk/>
            <pc:sldMk cId="2851950515" sldId="1547"/>
            <ac:spMk id="11" creationId="{56ED5E6C-86B9-4BCB-B208-A58B16C77D52}"/>
          </ac:spMkLst>
        </pc:spChg>
        <pc:spChg chg="mod">
          <ac:chgData name="佐伯　吉弘" userId="S::iop890@hiroshima-u.ac.jp::c48215f7-a175-419d-95e9-d9045df60879" providerId="AD" clId="Web-{BF904567-1496-26FD-59B2-275298C438AB}" dt="2023-08-05T06:18:47.572" v="6" actId="20577"/>
          <ac:spMkLst>
            <pc:docMk/>
            <pc:sldMk cId="2851950515" sldId="1547"/>
            <ac:spMk id="12" creationId="{443B432C-E7EF-43E1-A922-96AF55CE5CCA}"/>
          </ac:spMkLst>
        </pc:spChg>
        <pc:spChg chg="mod">
          <ac:chgData name="佐伯　吉弘" userId="S::iop890@hiroshima-u.ac.jp::c48215f7-a175-419d-95e9-d9045df60879" providerId="AD" clId="Web-{BF904567-1496-26FD-59B2-275298C438AB}" dt="2023-08-05T06:18:47.588" v="7" actId="20577"/>
          <ac:spMkLst>
            <pc:docMk/>
            <pc:sldMk cId="2851950515" sldId="1547"/>
            <ac:spMk id="13" creationId="{21696853-FAF2-492B-A959-96D21B782645}"/>
          </ac:spMkLst>
        </pc:spChg>
        <pc:spChg chg="mod">
          <ac:chgData name="佐伯　吉弘" userId="S::iop890@hiroshima-u.ac.jp::c48215f7-a175-419d-95e9-d9045df60879" providerId="AD" clId="Web-{BF904567-1496-26FD-59B2-275298C438AB}" dt="2023-08-05T06:18:47.619" v="8" actId="20577"/>
          <ac:spMkLst>
            <pc:docMk/>
            <pc:sldMk cId="2851950515" sldId="1547"/>
            <ac:spMk id="14" creationId="{2072F15C-001C-4DF3-BC33-361F2B8AD709}"/>
          </ac:spMkLst>
        </pc:spChg>
        <pc:spChg chg="mod">
          <ac:chgData name="佐伯　吉弘" userId="S::iop890@hiroshima-u.ac.jp::c48215f7-a175-419d-95e9-d9045df60879" providerId="AD" clId="Web-{BF904567-1496-26FD-59B2-275298C438AB}" dt="2023-08-05T06:18:47.650" v="9" actId="20577"/>
          <ac:spMkLst>
            <pc:docMk/>
            <pc:sldMk cId="2851950515" sldId="1547"/>
            <ac:spMk id="15" creationId="{7141E4D3-468E-4BA0-87E8-69CED0C3E111}"/>
          </ac:spMkLst>
        </pc:spChg>
        <pc:spChg chg="mod">
          <ac:chgData name="佐伯　吉弘" userId="S::iop890@hiroshima-u.ac.jp::c48215f7-a175-419d-95e9-d9045df60879" providerId="AD" clId="Web-{BF904567-1496-26FD-59B2-275298C438AB}" dt="2023-08-05T06:18:47.666" v="10" actId="20577"/>
          <ac:spMkLst>
            <pc:docMk/>
            <pc:sldMk cId="2851950515" sldId="1547"/>
            <ac:spMk id="16" creationId="{10F20B14-D218-483F-85B4-A04922286EB9}"/>
          </ac:spMkLst>
        </pc:spChg>
        <pc:spChg chg="mod">
          <ac:chgData name="佐伯　吉弘" userId="S::iop890@hiroshima-u.ac.jp::c48215f7-a175-419d-95e9-d9045df60879" providerId="AD" clId="Web-{BF904567-1496-26FD-59B2-275298C438AB}" dt="2023-08-05T06:18:47.697" v="11" actId="20577"/>
          <ac:spMkLst>
            <pc:docMk/>
            <pc:sldMk cId="2851950515" sldId="1547"/>
            <ac:spMk id="17" creationId="{5EFCC239-C17A-4E6B-8B2C-186D783DA2B1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hiroshimauniv-my.sharepoint.com/personal/d191386_hiroshima-u_ac_jp/Documents/team%20adipose/2.%20&#35542;&#25991;/surgery%20today%20&#35542;&#25991;/&#12487;&#12540;&#12479;/&#12487;&#12540;&#12479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hiroshimauniv-my.sharepoint.com/personal/d191386_hiroshima-u_ac_jp/Documents/team%20adipose/2.%20&#35542;&#25991;/surgery%20today%20&#35542;&#25991;/&#12487;&#12540;&#12479;/&#12487;&#12540;&#12479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https://hiroshimauniv-my.sharepoint.com/personal/d191386_hiroshima-u_ac_jp/Documents/team%20adipose/2.%20&#35542;&#25991;/surgery%20today%20&#35542;&#25991;/&#12487;&#12540;&#12479;/&#12487;&#12540;&#12479;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234325396825397"/>
          <c:y val="5.9609148318825737E-2"/>
          <c:w val="0.80993022486772481"/>
          <c:h val="0.82128093531319335"/>
        </c:manualLayout>
      </c:layout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numRef>
              <c:f>Suplグラフ!$B$2:$B$36</c:f>
              <c:numCache>
                <c:formatCode>General</c:formatCode>
                <c:ptCount val="35"/>
                <c:pt idx="0">
                  <c:v>110.74885695260465</c:v>
                </c:pt>
                <c:pt idx="1">
                  <c:v>66.399442314395287</c:v>
                </c:pt>
                <c:pt idx="2">
                  <c:v>35.954762371706863</c:v>
                </c:pt>
                <c:pt idx="3">
                  <c:v>31.94570135746606</c:v>
                </c:pt>
                <c:pt idx="4">
                  <c:v>50.121761766805228</c:v>
                </c:pt>
                <c:pt idx="5">
                  <c:v>54.07651747531046</c:v>
                </c:pt>
                <c:pt idx="6">
                  <c:v>50.664340433399872</c:v>
                </c:pt>
                <c:pt idx="7">
                  <c:v>46.702490236133741</c:v>
                </c:pt>
                <c:pt idx="8">
                  <c:v>34.577766121950319</c:v>
                </c:pt>
                <c:pt idx="9">
                  <c:v>38.008054908180398</c:v>
                </c:pt>
                <c:pt idx="10">
                  <c:v>17.142597415013856</c:v>
                </c:pt>
                <c:pt idx="11">
                  <c:v>29.076482037549489</c:v>
                </c:pt>
                <c:pt idx="12">
                  <c:v>51.605344640017869</c:v>
                </c:pt>
                <c:pt idx="13">
                  <c:v>72.426046216870731</c:v>
                </c:pt>
                <c:pt idx="14">
                  <c:v>77.784842606728233</c:v>
                </c:pt>
                <c:pt idx="15">
                  <c:v>27.152275452207437</c:v>
                </c:pt>
                <c:pt idx="17">
                  <c:v>56.957519183608895</c:v>
                </c:pt>
                <c:pt idx="18">
                  <c:v>12.642410878353557</c:v>
                </c:pt>
                <c:pt idx="19">
                  <c:v>28.844821307137732</c:v>
                </c:pt>
                <c:pt idx="20">
                  <c:v>35.261764427774466</c:v>
                </c:pt>
                <c:pt idx="21">
                  <c:v>70.182188686773657</c:v>
                </c:pt>
                <c:pt idx="22">
                  <c:v>77.58771084116097</c:v>
                </c:pt>
                <c:pt idx="23">
                  <c:v>86.563701631039251</c:v>
                </c:pt>
                <c:pt idx="25">
                  <c:v>28.598460536698315</c:v>
                </c:pt>
                <c:pt idx="26">
                  <c:v>54.816181315061272</c:v>
                </c:pt>
                <c:pt idx="27">
                  <c:v>48.97517171729465</c:v>
                </c:pt>
                <c:pt idx="28">
                  <c:v>34.548099559018503</c:v>
                </c:pt>
                <c:pt idx="29">
                  <c:v>50.962918632323571</c:v>
                </c:pt>
                <c:pt idx="31">
                  <c:v>60.338933891317382</c:v>
                </c:pt>
                <c:pt idx="32">
                  <c:v>44.779626599984908</c:v>
                </c:pt>
                <c:pt idx="33">
                  <c:v>21.978728878977609</c:v>
                </c:pt>
                <c:pt idx="34">
                  <c:v>71.649368461995138</c:v>
                </c:pt>
              </c:numCache>
            </c:numRef>
          </c:xVal>
          <c:yVal>
            <c:numRef>
              <c:f>Suplグラフ!$F$2:$F$36</c:f>
              <c:numCache>
                <c:formatCode>General</c:formatCode>
                <c:ptCount val="35"/>
                <c:pt idx="0">
                  <c:v>0.16</c:v>
                </c:pt>
                <c:pt idx="1">
                  <c:v>1.2</c:v>
                </c:pt>
                <c:pt idx="2">
                  <c:v>0.64</c:v>
                </c:pt>
                <c:pt idx="3">
                  <c:v>0.9</c:v>
                </c:pt>
                <c:pt idx="4">
                  <c:v>7.0000000000000007E-2</c:v>
                </c:pt>
                <c:pt idx="5">
                  <c:v>3.12</c:v>
                </c:pt>
                <c:pt idx="6">
                  <c:v>0.81</c:v>
                </c:pt>
                <c:pt idx="7">
                  <c:v>0.19</c:v>
                </c:pt>
                <c:pt idx="9">
                  <c:v>1.64</c:v>
                </c:pt>
                <c:pt idx="10">
                  <c:v>0.19</c:v>
                </c:pt>
                <c:pt idx="11">
                  <c:v>0.22</c:v>
                </c:pt>
                <c:pt idx="12">
                  <c:v>0.35</c:v>
                </c:pt>
                <c:pt idx="13">
                  <c:v>0.66</c:v>
                </c:pt>
                <c:pt idx="14">
                  <c:v>0.52</c:v>
                </c:pt>
                <c:pt idx="15">
                  <c:v>0.94</c:v>
                </c:pt>
                <c:pt idx="16">
                  <c:v>0.26</c:v>
                </c:pt>
                <c:pt idx="17">
                  <c:v>0.05</c:v>
                </c:pt>
                <c:pt idx="18">
                  <c:v>2.33</c:v>
                </c:pt>
                <c:pt idx="19">
                  <c:v>0.95</c:v>
                </c:pt>
                <c:pt idx="20">
                  <c:v>0.14000000000000001</c:v>
                </c:pt>
                <c:pt idx="21">
                  <c:v>0.23</c:v>
                </c:pt>
                <c:pt idx="22">
                  <c:v>0.48</c:v>
                </c:pt>
                <c:pt idx="23">
                  <c:v>0.55000000000000004</c:v>
                </c:pt>
                <c:pt idx="24">
                  <c:v>0.28999999999999998</c:v>
                </c:pt>
                <c:pt idx="25">
                  <c:v>1</c:v>
                </c:pt>
                <c:pt idx="26">
                  <c:v>0.08</c:v>
                </c:pt>
                <c:pt idx="28">
                  <c:v>0.25</c:v>
                </c:pt>
                <c:pt idx="29">
                  <c:v>0.4</c:v>
                </c:pt>
                <c:pt idx="30">
                  <c:v>0.22</c:v>
                </c:pt>
                <c:pt idx="31">
                  <c:v>0.19</c:v>
                </c:pt>
                <c:pt idx="32">
                  <c:v>0.3</c:v>
                </c:pt>
                <c:pt idx="33">
                  <c:v>0.2</c:v>
                </c:pt>
                <c:pt idx="34">
                  <c:v>0.6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5FE2-46AD-83DE-EE84B42E2A2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88220664"/>
        <c:axId val="688216824"/>
      </c:scatterChart>
      <c:valAx>
        <c:axId val="6882206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88216824"/>
        <c:crosses val="autoZero"/>
        <c:crossBetween val="midCat"/>
      </c:valAx>
      <c:valAx>
        <c:axId val="68821682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8822066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dPt>
            <c:idx val="5"/>
            <c:marker>
              <c:symbol val="circle"/>
              <c:size val="3"/>
              <c:spPr>
                <a:solidFill>
                  <a:schemeClr val="tx1"/>
                </a:solidFill>
                <a:ln w="6350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BE3A-4935-9F34-E18B135F7347}"/>
              </c:ext>
            </c:extLst>
          </c:dPt>
          <c:xVal>
            <c:numRef>
              <c:f>Suplグラフ!$B$2:$B$36</c:f>
              <c:numCache>
                <c:formatCode>General</c:formatCode>
                <c:ptCount val="35"/>
                <c:pt idx="0">
                  <c:v>110.74885695260465</c:v>
                </c:pt>
                <c:pt idx="1">
                  <c:v>66.399442314395287</c:v>
                </c:pt>
                <c:pt idx="2">
                  <c:v>35.954762371706863</c:v>
                </c:pt>
                <c:pt idx="3">
                  <c:v>31.94570135746606</c:v>
                </c:pt>
                <c:pt idx="4">
                  <c:v>50.121761766805228</c:v>
                </c:pt>
                <c:pt idx="5">
                  <c:v>54.07651747531046</c:v>
                </c:pt>
                <c:pt idx="6">
                  <c:v>50.664340433399872</c:v>
                </c:pt>
                <c:pt idx="7">
                  <c:v>46.702490236133741</c:v>
                </c:pt>
                <c:pt idx="8">
                  <c:v>34.577766121950319</c:v>
                </c:pt>
                <c:pt idx="9">
                  <c:v>38.008054908180398</c:v>
                </c:pt>
                <c:pt idx="10">
                  <c:v>17.142597415013856</c:v>
                </c:pt>
                <c:pt idx="11">
                  <c:v>29.076482037549489</c:v>
                </c:pt>
                <c:pt idx="12">
                  <c:v>51.605344640017869</c:v>
                </c:pt>
                <c:pt idx="13">
                  <c:v>72.426046216870731</c:v>
                </c:pt>
                <c:pt idx="14">
                  <c:v>77.784842606728233</c:v>
                </c:pt>
                <c:pt idx="15">
                  <c:v>27.152275452207437</c:v>
                </c:pt>
                <c:pt idx="17">
                  <c:v>56.957519183608895</c:v>
                </c:pt>
                <c:pt idx="18">
                  <c:v>12.642410878353557</c:v>
                </c:pt>
                <c:pt idx="19">
                  <c:v>28.844821307137732</c:v>
                </c:pt>
                <c:pt idx="20">
                  <c:v>35.261764427774466</c:v>
                </c:pt>
                <c:pt idx="21">
                  <c:v>70.182188686773657</c:v>
                </c:pt>
                <c:pt idx="22">
                  <c:v>77.58771084116097</c:v>
                </c:pt>
                <c:pt idx="23">
                  <c:v>86.563701631039251</c:v>
                </c:pt>
                <c:pt idx="25">
                  <c:v>28.598460536698315</c:v>
                </c:pt>
                <c:pt idx="26">
                  <c:v>54.816181315061272</c:v>
                </c:pt>
                <c:pt idx="27">
                  <c:v>48.97517171729465</c:v>
                </c:pt>
                <c:pt idx="28">
                  <c:v>34.548099559018503</c:v>
                </c:pt>
                <c:pt idx="29">
                  <c:v>50.962918632323571</c:v>
                </c:pt>
                <c:pt idx="31">
                  <c:v>60.338933891317382</c:v>
                </c:pt>
                <c:pt idx="32">
                  <c:v>44.779626599984908</c:v>
                </c:pt>
                <c:pt idx="33">
                  <c:v>21.978728878977609</c:v>
                </c:pt>
                <c:pt idx="34">
                  <c:v>71.649368461995138</c:v>
                </c:pt>
              </c:numCache>
            </c:numRef>
          </c:xVal>
          <c:yVal>
            <c:numRef>
              <c:f>Suplグラフ!$G$2:$G$36</c:f>
              <c:numCache>
                <c:formatCode>General</c:formatCode>
                <c:ptCount val="35"/>
                <c:pt idx="0">
                  <c:v>6.83</c:v>
                </c:pt>
                <c:pt idx="1">
                  <c:v>10.53</c:v>
                </c:pt>
                <c:pt idx="2">
                  <c:v>11.65</c:v>
                </c:pt>
                <c:pt idx="3">
                  <c:v>8.89</c:v>
                </c:pt>
                <c:pt idx="4">
                  <c:v>7.68</c:v>
                </c:pt>
                <c:pt idx="5">
                  <c:v>10.53</c:v>
                </c:pt>
                <c:pt idx="6">
                  <c:v>7.91</c:v>
                </c:pt>
                <c:pt idx="7">
                  <c:v>3.85</c:v>
                </c:pt>
                <c:pt idx="8">
                  <c:v>7.46</c:v>
                </c:pt>
                <c:pt idx="9">
                  <c:v>8.11</c:v>
                </c:pt>
                <c:pt idx="10">
                  <c:v>5.0999999999999996</c:v>
                </c:pt>
                <c:pt idx="11">
                  <c:v>4.43</c:v>
                </c:pt>
                <c:pt idx="12">
                  <c:v>6.71</c:v>
                </c:pt>
                <c:pt idx="13">
                  <c:v>10.06</c:v>
                </c:pt>
                <c:pt idx="14">
                  <c:v>9.09</c:v>
                </c:pt>
                <c:pt idx="15">
                  <c:v>7.65</c:v>
                </c:pt>
                <c:pt idx="16">
                  <c:v>9.68</c:v>
                </c:pt>
                <c:pt idx="17">
                  <c:v>5.29</c:v>
                </c:pt>
                <c:pt idx="18">
                  <c:v>13.81</c:v>
                </c:pt>
                <c:pt idx="19">
                  <c:v>9.8699999999999992</c:v>
                </c:pt>
                <c:pt idx="20">
                  <c:v>5.33</c:v>
                </c:pt>
                <c:pt idx="21">
                  <c:v>9.6199999999999992</c:v>
                </c:pt>
                <c:pt idx="22">
                  <c:v>9.68</c:v>
                </c:pt>
                <c:pt idx="23">
                  <c:v>5.9</c:v>
                </c:pt>
                <c:pt idx="24">
                  <c:v>5.99</c:v>
                </c:pt>
                <c:pt idx="25">
                  <c:v>10.23</c:v>
                </c:pt>
                <c:pt idx="26">
                  <c:v>5.71</c:v>
                </c:pt>
                <c:pt idx="27">
                  <c:v>5.49</c:v>
                </c:pt>
                <c:pt idx="28">
                  <c:v>7.5</c:v>
                </c:pt>
                <c:pt idx="29">
                  <c:v>6.55</c:v>
                </c:pt>
                <c:pt idx="30">
                  <c:v>6.9</c:v>
                </c:pt>
                <c:pt idx="31">
                  <c:v>7.49</c:v>
                </c:pt>
                <c:pt idx="32">
                  <c:v>6.06</c:v>
                </c:pt>
                <c:pt idx="33">
                  <c:v>5</c:v>
                </c:pt>
                <c:pt idx="34">
                  <c:v>8.8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BE3A-4935-9F34-E18B135F734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88220664"/>
        <c:axId val="688216824"/>
      </c:scatterChart>
      <c:valAx>
        <c:axId val="688220664"/>
        <c:scaling>
          <c:orientation val="minMax"/>
          <c:max val="15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88216824"/>
        <c:crosses val="autoZero"/>
        <c:crossBetween val="midCat"/>
      </c:valAx>
      <c:valAx>
        <c:axId val="68821682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8822066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numRef>
              <c:f>Suplグラフ!$B$2:$B$36</c:f>
              <c:numCache>
                <c:formatCode>General</c:formatCode>
                <c:ptCount val="35"/>
                <c:pt idx="0">
                  <c:v>110.74885695260465</c:v>
                </c:pt>
                <c:pt idx="1">
                  <c:v>66.399442314395287</c:v>
                </c:pt>
                <c:pt idx="2">
                  <c:v>35.954762371706863</c:v>
                </c:pt>
                <c:pt idx="3">
                  <c:v>31.94570135746606</c:v>
                </c:pt>
                <c:pt idx="4">
                  <c:v>50.121761766805228</c:v>
                </c:pt>
                <c:pt idx="5">
                  <c:v>54.07651747531046</c:v>
                </c:pt>
                <c:pt idx="6">
                  <c:v>50.664340433399872</c:v>
                </c:pt>
                <c:pt idx="7">
                  <c:v>46.702490236133741</c:v>
                </c:pt>
                <c:pt idx="8">
                  <c:v>34.577766121950319</c:v>
                </c:pt>
                <c:pt idx="9">
                  <c:v>38.008054908180398</c:v>
                </c:pt>
                <c:pt idx="10">
                  <c:v>17.142597415013856</c:v>
                </c:pt>
                <c:pt idx="11">
                  <c:v>29.076482037549489</c:v>
                </c:pt>
                <c:pt idx="12">
                  <c:v>51.605344640017869</c:v>
                </c:pt>
                <c:pt idx="13">
                  <c:v>72.426046216870731</c:v>
                </c:pt>
                <c:pt idx="14">
                  <c:v>77.784842606728233</c:v>
                </c:pt>
                <c:pt idx="15">
                  <c:v>27.152275452207437</c:v>
                </c:pt>
                <c:pt idx="17">
                  <c:v>56.957519183608895</c:v>
                </c:pt>
                <c:pt idx="18">
                  <c:v>12.642410878353557</c:v>
                </c:pt>
                <c:pt idx="19">
                  <c:v>28.844821307137732</c:v>
                </c:pt>
                <c:pt idx="20">
                  <c:v>35.261764427774466</c:v>
                </c:pt>
                <c:pt idx="21">
                  <c:v>70.182188686773657</c:v>
                </c:pt>
                <c:pt idx="22">
                  <c:v>77.58771084116097</c:v>
                </c:pt>
                <c:pt idx="23">
                  <c:v>86.563701631039251</c:v>
                </c:pt>
                <c:pt idx="25">
                  <c:v>28.598460536698315</c:v>
                </c:pt>
                <c:pt idx="26">
                  <c:v>54.816181315061272</c:v>
                </c:pt>
                <c:pt idx="27">
                  <c:v>48.97517171729465</c:v>
                </c:pt>
                <c:pt idx="28">
                  <c:v>34.548099559018503</c:v>
                </c:pt>
                <c:pt idx="29">
                  <c:v>50.962918632323571</c:v>
                </c:pt>
                <c:pt idx="31">
                  <c:v>60.338933891317382</c:v>
                </c:pt>
                <c:pt idx="32">
                  <c:v>44.779626599984908</c:v>
                </c:pt>
                <c:pt idx="33">
                  <c:v>21.978728878977609</c:v>
                </c:pt>
                <c:pt idx="34">
                  <c:v>71.649368461995138</c:v>
                </c:pt>
              </c:numCache>
            </c:numRef>
          </c:xVal>
          <c:yVal>
            <c:numRef>
              <c:f>Suplグラフ!$E$2:$E$36</c:f>
              <c:numCache>
                <c:formatCode>General</c:formatCode>
                <c:ptCount val="35"/>
                <c:pt idx="0">
                  <c:v>2</c:v>
                </c:pt>
                <c:pt idx="1">
                  <c:v>3.37</c:v>
                </c:pt>
                <c:pt idx="2">
                  <c:v>3.46</c:v>
                </c:pt>
                <c:pt idx="3">
                  <c:v>2.4300000000000002</c:v>
                </c:pt>
                <c:pt idx="4">
                  <c:v>2.3199999999999998</c:v>
                </c:pt>
                <c:pt idx="5">
                  <c:v>2.88</c:v>
                </c:pt>
                <c:pt idx="6">
                  <c:v>1.92</c:v>
                </c:pt>
                <c:pt idx="7">
                  <c:v>1.06</c:v>
                </c:pt>
                <c:pt idx="8">
                  <c:v>2.42</c:v>
                </c:pt>
                <c:pt idx="9">
                  <c:v>2.2599999999999998</c:v>
                </c:pt>
                <c:pt idx="10">
                  <c:v>2.34</c:v>
                </c:pt>
                <c:pt idx="11">
                  <c:v>1.07</c:v>
                </c:pt>
                <c:pt idx="12">
                  <c:v>1.74</c:v>
                </c:pt>
                <c:pt idx="14">
                  <c:v>2.41</c:v>
                </c:pt>
                <c:pt idx="15">
                  <c:v>2.31</c:v>
                </c:pt>
                <c:pt idx="16">
                  <c:v>3.07</c:v>
                </c:pt>
                <c:pt idx="17">
                  <c:v>1.02</c:v>
                </c:pt>
                <c:pt idx="18">
                  <c:v>3.03</c:v>
                </c:pt>
                <c:pt idx="19">
                  <c:v>3</c:v>
                </c:pt>
                <c:pt idx="20">
                  <c:v>1.96</c:v>
                </c:pt>
                <c:pt idx="21">
                  <c:v>1.93</c:v>
                </c:pt>
                <c:pt idx="22">
                  <c:v>2.5299999999999998</c:v>
                </c:pt>
                <c:pt idx="23">
                  <c:v>1.91</c:v>
                </c:pt>
                <c:pt idx="24">
                  <c:v>2.34</c:v>
                </c:pt>
                <c:pt idx="25">
                  <c:v>2.48</c:v>
                </c:pt>
                <c:pt idx="26">
                  <c:v>2.5299999999999998</c:v>
                </c:pt>
                <c:pt idx="27">
                  <c:v>1.78</c:v>
                </c:pt>
                <c:pt idx="28">
                  <c:v>1.92</c:v>
                </c:pt>
                <c:pt idx="29">
                  <c:v>1.79</c:v>
                </c:pt>
                <c:pt idx="30">
                  <c:v>2.09</c:v>
                </c:pt>
                <c:pt idx="31">
                  <c:v>2.2999999999999998</c:v>
                </c:pt>
                <c:pt idx="32">
                  <c:v>2.0099999999999998</c:v>
                </c:pt>
                <c:pt idx="33">
                  <c:v>1.46</c:v>
                </c:pt>
                <c:pt idx="34">
                  <c:v>3.3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975B-4DCD-84CD-0EEEA69A61F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88220664"/>
        <c:axId val="688216824"/>
      </c:scatterChart>
      <c:valAx>
        <c:axId val="688220664"/>
        <c:scaling>
          <c:orientation val="minMax"/>
          <c:max val="15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88216824"/>
        <c:crosses val="autoZero"/>
        <c:crossBetween val="midCat"/>
      </c:valAx>
      <c:valAx>
        <c:axId val="68821682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8822066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226083-64BA-4969-B66C-4DBCD5415493}" type="datetimeFigureOut">
              <a:rPr kumimoji="1" lang="ja-JP" altLang="en-US" smtClean="0"/>
              <a:t>2023/8/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7BA97C7-1FFA-4487-ADDC-613D98C005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92530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ja-JP" dirty="0"/>
              <a:t>(a) The correlation between the WBC counts and </a:t>
            </a:r>
            <a:r>
              <a:rPr lang="en-US" altLang="ja-JP" sz="12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ostoperative EWL at 12 months</a:t>
            </a:r>
            <a:r>
              <a:rPr lang="en-US" altLang="ja-JP" dirty="0"/>
              <a:t> </a:t>
            </a:r>
          </a:p>
          <a:p>
            <a:r>
              <a:rPr lang="en-US" altLang="ja-JP" dirty="0"/>
              <a:t>(b) The correlation between the CRP levels and </a:t>
            </a:r>
            <a:r>
              <a:rPr lang="en-US" altLang="ja-JP" sz="12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ostoperative EWL at 12 months</a:t>
            </a:r>
            <a:r>
              <a:rPr lang="en-US" altLang="ja-JP" dirty="0"/>
              <a:t> </a:t>
            </a:r>
          </a:p>
          <a:p>
            <a:r>
              <a:rPr kumimoji="1" lang="en-US" altLang="ja-JP" dirty="0"/>
              <a:t>(c) </a:t>
            </a:r>
            <a:r>
              <a:rPr lang="en-US" altLang="ja-JP" dirty="0"/>
              <a:t>The correlation between the lymphocyte counts and </a:t>
            </a:r>
            <a:r>
              <a:rPr lang="en-US" altLang="ja-JP" sz="12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ostoperative EWL at 12 months</a:t>
            </a:r>
            <a:r>
              <a:rPr lang="en-US" altLang="ja-JP" dirty="0"/>
              <a:t> </a:t>
            </a:r>
            <a:endParaRPr lang="en-US" altLang="ja-JP" b="0" i="0" dirty="0">
              <a:solidFill>
                <a:srgbClr val="333333"/>
              </a:solidFill>
              <a:effectLst/>
              <a:latin typeface="-apple-system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ja-JP" b="0" i="0" dirty="0">
              <a:solidFill>
                <a:srgbClr val="333333"/>
              </a:solidFill>
              <a:effectLst/>
              <a:latin typeface="-apple-system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b="0" i="0" dirty="0">
                <a:solidFill>
                  <a:srgbClr val="333333"/>
                </a:solidFill>
                <a:effectLst/>
                <a:latin typeface="-apple-system"/>
              </a:rPr>
              <a:t>Figures should be 39 mm, 84 mm, 129 mm, or 174 mm wide and not higher than 234 mm</a:t>
            </a:r>
            <a:endParaRPr kumimoji="1" lang="ja-JP" altLang="en-US" dirty="0"/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7BA97C7-1FFA-4487-ADDC-613D98C0051E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00291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64BE7-4756-4F8B-95AF-AA1714C89953}" type="datetimeFigureOut">
              <a:rPr kumimoji="1" lang="ja-JP" altLang="en-US" smtClean="0"/>
              <a:t>2023/8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78C7-D226-4B46-B47B-EA18D98018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11834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64BE7-4756-4F8B-95AF-AA1714C89953}" type="datetimeFigureOut">
              <a:rPr kumimoji="1" lang="ja-JP" altLang="en-US" smtClean="0"/>
              <a:t>2023/8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78C7-D226-4B46-B47B-EA18D98018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93263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64BE7-4756-4F8B-95AF-AA1714C89953}" type="datetimeFigureOut">
              <a:rPr kumimoji="1" lang="ja-JP" altLang="en-US" smtClean="0"/>
              <a:t>2023/8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78C7-D226-4B46-B47B-EA18D98018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06521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64BE7-4756-4F8B-95AF-AA1714C89953}" type="datetimeFigureOut">
              <a:rPr kumimoji="1" lang="ja-JP" altLang="en-US" smtClean="0"/>
              <a:t>2023/8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78C7-D226-4B46-B47B-EA18D98018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61739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64BE7-4756-4F8B-95AF-AA1714C89953}" type="datetimeFigureOut">
              <a:rPr kumimoji="1" lang="ja-JP" altLang="en-US" smtClean="0"/>
              <a:t>2023/8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78C7-D226-4B46-B47B-EA18D98018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2375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64BE7-4756-4F8B-95AF-AA1714C89953}" type="datetimeFigureOut">
              <a:rPr kumimoji="1" lang="ja-JP" altLang="en-US" smtClean="0"/>
              <a:t>2023/8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78C7-D226-4B46-B47B-EA18D98018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56551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64BE7-4756-4F8B-95AF-AA1714C89953}" type="datetimeFigureOut">
              <a:rPr kumimoji="1" lang="ja-JP" altLang="en-US" smtClean="0"/>
              <a:t>2023/8/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78C7-D226-4B46-B47B-EA18D98018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10081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64BE7-4756-4F8B-95AF-AA1714C89953}" type="datetimeFigureOut">
              <a:rPr kumimoji="1" lang="ja-JP" altLang="en-US" smtClean="0"/>
              <a:t>2023/8/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78C7-D226-4B46-B47B-EA18D98018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90659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64BE7-4756-4F8B-95AF-AA1714C89953}" type="datetimeFigureOut">
              <a:rPr kumimoji="1" lang="ja-JP" altLang="en-US" smtClean="0"/>
              <a:t>2023/8/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78C7-D226-4B46-B47B-EA18D98018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86021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64BE7-4756-4F8B-95AF-AA1714C89953}" type="datetimeFigureOut">
              <a:rPr kumimoji="1" lang="ja-JP" altLang="en-US" smtClean="0"/>
              <a:t>2023/8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78C7-D226-4B46-B47B-EA18D98018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56424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64BE7-4756-4F8B-95AF-AA1714C89953}" type="datetimeFigureOut">
              <a:rPr kumimoji="1" lang="ja-JP" altLang="en-US" smtClean="0"/>
              <a:t>2023/8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78C7-D226-4B46-B47B-EA18D98018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83718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064BE7-4756-4F8B-95AF-AA1714C89953}" type="datetimeFigureOut">
              <a:rPr kumimoji="1" lang="ja-JP" altLang="en-US" smtClean="0"/>
              <a:t>2023/8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B478C7-D226-4B46-B47B-EA18D98018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30196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0" name="グラフ 19">
            <a:extLst>
              <a:ext uri="{FF2B5EF4-FFF2-40B4-BE49-F238E27FC236}">
                <a16:creationId xmlns:a16="http://schemas.microsoft.com/office/drawing/2014/main" id="{F2C967B2-17C4-452C-9CB3-B2E11D88C0B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30150261"/>
              </p:ext>
            </p:extLst>
          </p:nvPr>
        </p:nvGraphicFramePr>
        <p:xfrm>
          <a:off x="4971301" y="657584"/>
          <a:ext cx="3024000" cy="2343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8" name="グラフ 17">
            <a:extLst>
              <a:ext uri="{FF2B5EF4-FFF2-40B4-BE49-F238E27FC236}">
                <a16:creationId xmlns:a16="http://schemas.microsoft.com/office/drawing/2014/main" id="{F2C967B2-17C4-452C-9CB3-B2E11D88C0B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25572528"/>
              </p:ext>
            </p:extLst>
          </p:nvPr>
        </p:nvGraphicFramePr>
        <p:xfrm>
          <a:off x="599219" y="654836"/>
          <a:ext cx="3024000" cy="2343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9" name="グラフ 18">
            <a:extLst>
              <a:ext uri="{FF2B5EF4-FFF2-40B4-BE49-F238E27FC236}">
                <a16:creationId xmlns:a16="http://schemas.microsoft.com/office/drawing/2014/main" id="{F2C967B2-17C4-452C-9CB3-B2E11D88C0B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99334443"/>
              </p:ext>
            </p:extLst>
          </p:nvPr>
        </p:nvGraphicFramePr>
        <p:xfrm>
          <a:off x="565456" y="3868428"/>
          <a:ext cx="3024000" cy="2343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80B36E8-F9F9-431F-99A2-B7594DBF4711}"/>
              </a:ext>
            </a:extLst>
          </p:cNvPr>
          <p:cNvSpPr txBox="1"/>
          <p:nvPr/>
        </p:nvSpPr>
        <p:spPr>
          <a:xfrm>
            <a:off x="7506" y="7895"/>
            <a:ext cx="19945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ry Fig. S2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55F8B415-BE9F-40E3-AF23-6EDD90F595EA}"/>
              </a:ext>
            </a:extLst>
          </p:cNvPr>
          <p:cNvSpPr txBox="1"/>
          <p:nvPr/>
        </p:nvSpPr>
        <p:spPr>
          <a:xfrm>
            <a:off x="281456" y="287027"/>
            <a:ext cx="305406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kumimoji="1" lang="en-US" altLang="ja-JP" dirty="0">
                <a:latin typeface="Arial"/>
                <a:ea typeface="游ゴシック"/>
                <a:cs typeface="Times New Roman"/>
              </a:rPr>
              <a:t>a</a:t>
            </a:r>
            <a:endParaRPr lang="ja-JP" altLang="en-US">
              <a:latin typeface="Arial"/>
              <a:ea typeface="游ゴシック"/>
              <a:cs typeface="Times New Roman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37F7D5CF-F508-41E9-9F90-E00439CC1A4F}"/>
              </a:ext>
            </a:extLst>
          </p:cNvPr>
          <p:cNvSpPr txBox="1"/>
          <p:nvPr/>
        </p:nvSpPr>
        <p:spPr>
          <a:xfrm rot="16200000">
            <a:off x="-529068" y="1612115"/>
            <a:ext cx="1926454" cy="276999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kumimoji="1" lang="en-US" altLang="ja-JP" sz="1200" dirty="0">
                <a:latin typeface="Arial"/>
                <a:ea typeface="游ゴシック"/>
                <a:cs typeface="Arial"/>
              </a:rPr>
              <a:t>WBC (×10</a:t>
            </a:r>
            <a:r>
              <a:rPr kumimoji="1" lang="en-US" altLang="ja-JP" sz="1200" baseline="30000" dirty="0">
                <a:latin typeface="Arial"/>
                <a:ea typeface="游ゴシック"/>
                <a:cs typeface="Arial"/>
              </a:rPr>
              <a:t>3</a:t>
            </a:r>
            <a:r>
              <a:rPr kumimoji="1" lang="en-US" altLang="ja-JP" sz="1200" dirty="0">
                <a:latin typeface="Arial"/>
                <a:ea typeface="游ゴシック"/>
                <a:cs typeface="Arial"/>
              </a:rPr>
              <a:t>/</a:t>
            </a:r>
            <a:r>
              <a:rPr kumimoji="1" lang="en-US" altLang="ja-JP" sz="1200" err="1">
                <a:latin typeface="Arial"/>
                <a:ea typeface="游ゴシック"/>
                <a:cs typeface="Arial"/>
              </a:rPr>
              <a:t>μl</a:t>
            </a:r>
            <a:r>
              <a:rPr kumimoji="1" lang="en-US" altLang="ja-JP" sz="1200" dirty="0">
                <a:latin typeface="Arial"/>
                <a:ea typeface="游ゴシック"/>
                <a:cs typeface="Arial"/>
              </a:rPr>
              <a:t>)</a:t>
            </a:r>
            <a:endParaRPr lang="ja-JP" altLang="en-US" sz="1200">
              <a:latin typeface="Arial"/>
              <a:ea typeface="游ゴシック"/>
              <a:cs typeface="Arial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28D50EB3-9B78-4649-9768-8DC770C7B018}"/>
              </a:ext>
            </a:extLst>
          </p:cNvPr>
          <p:cNvSpPr txBox="1"/>
          <p:nvPr/>
        </p:nvSpPr>
        <p:spPr>
          <a:xfrm>
            <a:off x="274042" y="3536415"/>
            <a:ext cx="263278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kumimoji="1" lang="en-US" altLang="ja-JP" dirty="0">
                <a:latin typeface="Arial"/>
                <a:ea typeface="游ゴシック"/>
                <a:cs typeface="Times New Roman"/>
              </a:rPr>
              <a:t>c</a:t>
            </a:r>
            <a:endParaRPr lang="ja-JP" altLang="en-US">
              <a:latin typeface="Arial"/>
              <a:ea typeface="游ゴシック"/>
              <a:cs typeface="Times New Roman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7B1777C7-5112-44A2-9F2B-5C50DDD4B3DA}"/>
              </a:ext>
            </a:extLst>
          </p:cNvPr>
          <p:cNvSpPr txBox="1"/>
          <p:nvPr/>
        </p:nvSpPr>
        <p:spPr>
          <a:xfrm rot="16200000">
            <a:off x="-550474" y="4968887"/>
            <a:ext cx="1926454" cy="276999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kumimoji="1" lang="en-US" altLang="ja-JP" sz="1200" dirty="0">
                <a:latin typeface="Arial"/>
                <a:ea typeface="游ゴシック"/>
                <a:cs typeface="Arial"/>
              </a:rPr>
              <a:t>Ly (×10</a:t>
            </a:r>
            <a:r>
              <a:rPr kumimoji="1" lang="en-US" altLang="ja-JP" sz="1200" baseline="30000" dirty="0">
                <a:latin typeface="Arial"/>
                <a:ea typeface="游ゴシック"/>
                <a:cs typeface="Arial"/>
              </a:rPr>
              <a:t>3</a:t>
            </a:r>
            <a:r>
              <a:rPr kumimoji="1" lang="en-US" altLang="ja-JP" sz="1200" dirty="0">
                <a:latin typeface="Arial"/>
                <a:ea typeface="游ゴシック"/>
                <a:cs typeface="Arial"/>
              </a:rPr>
              <a:t>/</a:t>
            </a:r>
            <a:r>
              <a:rPr kumimoji="1" lang="en-US" altLang="ja-JP" sz="1200" err="1">
                <a:latin typeface="Arial"/>
                <a:ea typeface="游ゴシック"/>
                <a:cs typeface="Arial"/>
              </a:rPr>
              <a:t>μl</a:t>
            </a:r>
            <a:r>
              <a:rPr kumimoji="1" lang="en-US" altLang="ja-JP" sz="1200" dirty="0">
                <a:latin typeface="Arial"/>
                <a:ea typeface="游ゴシック"/>
                <a:cs typeface="Arial"/>
              </a:rPr>
              <a:t>)</a:t>
            </a:r>
            <a:endParaRPr lang="ja-JP" altLang="en-US" sz="1200">
              <a:latin typeface="Arial"/>
              <a:ea typeface="游ゴシック"/>
              <a:cs typeface="Arial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7A3DBBF8-AE95-4DC1-A405-7F893F4609FF}"/>
              </a:ext>
            </a:extLst>
          </p:cNvPr>
          <p:cNvSpPr txBox="1"/>
          <p:nvPr/>
        </p:nvSpPr>
        <p:spPr>
          <a:xfrm>
            <a:off x="4687598" y="287027"/>
            <a:ext cx="305406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kumimoji="1" lang="en-US" altLang="ja-JP" dirty="0">
                <a:latin typeface="Arial"/>
                <a:ea typeface="游ゴシック"/>
                <a:cs typeface="Times New Roman"/>
              </a:rPr>
              <a:t>b</a:t>
            </a:r>
            <a:endParaRPr lang="ja-JP" altLang="en-US">
              <a:latin typeface="Arial"/>
              <a:ea typeface="游ゴシック"/>
              <a:cs typeface="Times New Roman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56ED5E6C-86B9-4BCB-B208-A58B16C77D52}"/>
              </a:ext>
            </a:extLst>
          </p:cNvPr>
          <p:cNvSpPr txBox="1"/>
          <p:nvPr/>
        </p:nvSpPr>
        <p:spPr>
          <a:xfrm rot="16200000">
            <a:off x="3877074" y="1618017"/>
            <a:ext cx="1926454" cy="276999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kumimoji="1" lang="en-US" altLang="ja-JP" sz="1200" dirty="0">
                <a:latin typeface="Arial"/>
                <a:ea typeface="游ゴシック"/>
                <a:cs typeface="Arial"/>
              </a:rPr>
              <a:t>CRP (mg/dl)</a:t>
            </a:r>
            <a:endParaRPr lang="ja-JP" altLang="en-US" sz="1200">
              <a:latin typeface="Arial"/>
              <a:ea typeface="游ゴシック"/>
              <a:cs typeface="Arial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443B432C-E7EF-43E1-A922-96AF55CE5CCA}"/>
              </a:ext>
            </a:extLst>
          </p:cNvPr>
          <p:cNvSpPr txBox="1"/>
          <p:nvPr/>
        </p:nvSpPr>
        <p:spPr>
          <a:xfrm>
            <a:off x="541539" y="2899758"/>
            <a:ext cx="3351180" cy="276999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 algn="ctr"/>
            <a:r>
              <a:rPr lang="en-US" altLang="ja-JP" sz="1200" dirty="0">
                <a:latin typeface="Arial"/>
                <a:ea typeface="游明朝"/>
                <a:cs typeface="Arial"/>
              </a:rPr>
              <a:t> </a:t>
            </a:r>
            <a:r>
              <a:rPr lang="en-US" altLang="ja-JP" sz="1200" dirty="0">
                <a:effectLst/>
                <a:latin typeface="Arial"/>
                <a:ea typeface="游明朝"/>
                <a:cs typeface="Arial"/>
              </a:rPr>
              <a:t>postoperative EWL at 12 months (%)</a:t>
            </a:r>
            <a:endParaRPr lang="ja-JP" altLang="ja-JP" sz="1200" kern="100">
              <a:effectLst/>
              <a:latin typeface="Arial"/>
              <a:ea typeface="游明朝"/>
              <a:cs typeface="Arial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21696853-FAF2-492B-A959-96D21B782645}"/>
              </a:ext>
            </a:extLst>
          </p:cNvPr>
          <p:cNvSpPr txBox="1"/>
          <p:nvPr/>
        </p:nvSpPr>
        <p:spPr>
          <a:xfrm>
            <a:off x="4857100" y="2899757"/>
            <a:ext cx="3351180" cy="276999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 algn="ctr"/>
            <a:r>
              <a:rPr lang="en-US" altLang="ja-JP" sz="1200" dirty="0">
                <a:latin typeface="Arial"/>
                <a:ea typeface="游明朝"/>
                <a:cs typeface="Arial"/>
              </a:rPr>
              <a:t> </a:t>
            </a:r>
            <a:r>
              <a:rPr lang="en-US" altLang="ja-JP" sz="1200" dirty="0">
                <a:effectLst/>
                <a:latin typeface="Arial"/>
                <a:ea typeface="游明朝"/>
                <a:cs typeface="Arial"/>
              </a:rPr>
              <a:t>postoperative EWL at 12 months (%)</a:t>
            </a:r>
            <a:endParaRPr lang="ja-JP" altLang="ja-JP" sz="1200" kern="100">
              <a:effectLst/>
              <a:latin typeface="Arial"/>
              <a:ea typeface="游明朝"/>
              <a:cs typeface="Arial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2072F15C-001C-4DF3-BC33-361F2B8AD709}"/>
              </a:ext>
            </a:extLst>
          </p:cNvPr>
          <p:cNvSpPr txBox="1"/>
          <p:nvPr/>
        </p:nvSpPr>
        <p:spPr>
          <a:xfrm>
            <a:off x="541539" y="6116646"/>
            <a:ext cx="3351180" cy="276999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 algn="ctr"/>
            <a:r>
              <a:rPr lang="en-US" altLang="ja-JP" sz="1200" dirty="0">
                <a:latin typeface="Arial"/>
                <a:ea typeface="游明朝"/>
                <a:cs typeface="Arial"/>
              </a:rPr>
              <a:t> </a:t>
            </a:r>
            <a:r>
              <a:rPr lang="en-US" altLang="ja-JP" sz="1200" dirty="0">
                <a:effectLst/>
                <a:latin typeface="Arial"/>
                <a:ea typeface="游明朝"/>
                <a:cs typeface="Arial"/>
              </a:rPr>
              <a:t>postoperative EWL at 12 months (%)</a:t>
            </a:r>
            <a:endParaRPr lang="ja-JP" altLang="ja-JP" sz="1200" kern="100">
              <a:effectLst/>
              <a:latin typeface="Arial"/>
              <a:ea typeface="游明朝"/>
              <a:cs typeface="Arial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7141E4D3-468E-4BA0-87E8-69CED0C3E111}"/>
              </a:ext>
            </a:extLst>
          </p:cNvPr>
          <p:cNvSpPr txBox="1"/>
          <p:nvPr/>
        </p:nvSpPr>
        <p:spPr>
          <a:xfrm>
            <a:off x="6788345" y="1125602"/>
            <a:ext cx="1068754" cy="461665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kumimoji="1" lang="en-US" altLang="ja-JP" sz="1200" i="1" dirty="0">
                <a:latin typeface="Arial"/>
                <a:ea typeface="游ゴシック"/>
                <a:cs typeface="Arial"/>
              </a:rPr>
              <a:t>r = </a:t>
            </a:r>
            <a:r>
              <a:rPr kumimoji="1" lang="en-US" altLang="ja-JP" sz="1200" dirty="0">
                <a:latin typeface="Arial"/>
                <a:ea typeface="游ゴシック"/>
                <a:cs typeface="Arial"/>
              </a:rPr>
              <a:t>-0.19</a:t>
            </a:r>
            <a:endParaRPr lang="en-US" altLang="ja-JP" sz="1200" dirty="0">
              <a:latin typeface="Arial"/>
              <a:ea typeface="游ゴシック"/>
              <a:cs typeface="Arial"/>
            </a:endParaRPr>
          </a:p>
          <a:p>
            <a:r>
              <a:rPr kumimoji="1" lang="en-US" altLang="ja-JP" sz="1200" i="1" dirty="0">
                <a:latin typeface="Arial"/>
                <a:ea typeface="游ゴシック"/>
                <a:cs typeface="Arial"/>
              </a:rPr>
              <a:t>p = </a:t>
            </a:r>
            <a:r>
              <a:rPr kumimoji="1" lang="en-US" altLang="ja-JP" sz="1200" b="0" dirty="0">
                <a:latin typeface="Arial"/>
                <a:ea typeface="游ゴシック"/>
                <a:cs typeface="Arial"/>
              </a:rPr>
              <a:t>.29</a:t>
            </a:r>
            <a:endParaRPr lang="ja-JP" altLang="en-US" sz="1200" b="0">
              <a:latin typeface="Arial"/>
              <a:ea typeface="游ゴシック"/>
              <a:cs typeface="Arial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10F20B14-D218-483F-85B4-A04922286EB9}"/>
              </a:ext>
            </a:extLst>
          </p:cNvPr>
          <p:cNvSpPr txBox="1"/>
          <p:nvPr/>
        </p:nvSpPr>
        <p:spPr>
          <a:xfrm>
            <a:off x="2553199" y="1125603"/>
            <a:ext cx="1068754" cy="461665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kumimoji="1" lang="en-US" altLang="ja-JP" sz="1200" i="1" dirty="0">
                <a:latin typeface="Arial"/>
                <a:ea typeface="游ゴシック"/>
                <a:cs typeface="Arial"/>
              </a:rPr>
              <a:t>r = </a:t>
            </a:r>
            <a:r>
              <a:rPr kumimoji="1" lang="en-US" altLang="ja-JP" sz="1200" dirty="0">
                <a:latin typeface="Arial"/>
                <a:ea typeface="游ゴシック"/>
                <a:cs typeface="Arial"/>
              </a:rPr>
              <a:t>0.003</a:t>
            </a:r>
            <a:endParaRPr lang="en-US" altLang="ja-JP" sz="1200" dirty="0">
              <a:latin typeface="Arial"/>
              <a:ea typeface="游ゴシック"/>
              <a:cs typeface="Arial"/>
            </a:endParaRPr>
          </a:p>
          <a:p>
            <a:r>
              <a:rPr kumimoji="1" lang="en-US" altLang="ja-JP" sz="1200" i="1" dirty="0">
                <a:latin typeface="Arial"/>
                <a:ea typeface="游ゴシック"/>
                <a:cs typeface="Arial"/>
              </a:rPr>
              <a:t>p = </a:t>
            </a:r>
            <a:r>
              <a:rPr kumimoji="1" lang="en-US" altLang="ja-JP" sz="1200" b="0" dirty="0">
                <a:latin typeface="Arial"/>
                <a:ea typeface="游ゴシック"/>
                <a:cs typeface="Arial"/>
              </a:rPr>
              <a:t>.98</a:t>
            </a:r>
            <a:endParaRPr lang="ja-JP" altLang="en-US" sz="1200" b="0">
              <a:latin typeface="Arial"/>
              <a:ea typeface="游ゴシック"/>
              <a:cs typeface="Arial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5EFCC239-C17A-4E6B-8B2C-186D783DA2B1}"/>
              </a:ext>
            </a:extLst>
          </p:cNvPr>
          <p:cNvSpPr txBox="1"/>
          <p:nvPr/>
        </p:nvSpPr>
        <p:spPr>
          <a:xfrm>
            <a:off x="2553199" y="4256741"/>
            <a:ext cx="1068754" cy="461665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kumimoji="1" lang="en-US" altLang="ja-JP" sz="1200" i="1" dirty="0">
                <a:latin typeface="Arial"/>
                <a:ea typeface="游ゴシック"/>
                <a:cs typeface="Arial"/>
              </a:rPr>
              <a:t>r = </a:t>
            </a:r>
            <a:r>
              <a:rPr kumimoji="1" lang="en-US" altLang="ja-JP" sz="1200" dirty="0">
                <a:latin typeface="Arial"/>
                <a:ea typeface="游ゴシック"/>
                <a:cs typeface="Arial"/>
              </a:rPr>
              <a:t>-0.004</a:t>
            </a:r>
            <a:endParaRPr lang="en-US" altLang="ja-JP" sz="1200" dirty="0">
              <a:latin typeface="Arial"/>
              <a:ea typeface="游ゴシック"/>
              <a:cs typeface="Arial"/>
            </a:endParaRPr>
          </a:p>
          <a:p>
            <a:r>
              <a:rPr kumimoji="1" lang="en-US" altLang="ja-JP" sz="1200" i="1" dirty="0">
                <a:latin typeface="Arial"/>
                <a:ea typeface="游ゴシック"/>
                <a:cs typeface="Arial"/>
              </a:rPr>
              <a:t>p = </a:t>
            </a:r>
            <a:r>
              <a:rPr kumimoji="1" lang="en-US" altLang="ja-JP" sz="1200" b="0" dirty="0">
                <a:latin typeface="Arial"/>
                <a:ea typeface="游ゴシック"/>
                <a:cs typeface="Arial"/>
              </a:rPr>
              <a:t>.98</a:t>
            </a:r>
            <a:endParaRPr lang="ja-JP" altLang="en-US" sz="1200" b="0">
              <a:latin typeface="Arial"/>
              <a:ea typeface="游ゴシック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8519505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137</Words>
  <Application>Microsoft Office PowerPoint</Application>
  <PresentationFormat>画面に合わせる (4:3)</PresentationFormat>
  <Paragraphs>22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-apple-system</vt:lpstr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rgery today figure</dc:title>
  <dc:creator>emichikuie@outlook.jp</dc:creator>
  <cp:lastModifiedBy>佐伯　吉弘</cp:lastModifiedBy>
  <cp:revision>64</cp:revision>
  <dcterms:created xsi:type="dcterms:W3CDTF">2021-09-12T14:20:25Z</dcterms:created>
  <dcterms:modified xsi:type="dcterms:W3CDTF">2023-08-05T07:03:39Z</dcterms:modified>
</cp:coreProperties>
</file>